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4">
  <dgm:title val=""/>
  <dgm:desc val=""/>
  <dgm:catLst>
    <dgm:cat type="colorful" pri="10400"/>
  </dgm:catLst>
  <dgm:styleLbl name="node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4"/>
      <a:schemeClr val="accent5"/>
    </dgm:fillClrLst>
    <dgm:linClrLst>
      <a:schemeClr val="accent4"/>
      <a:schemeClr val="accent5"/>
    </dgm:linClrLst>
    <dgm:effectClrLst/>
    <dgm:txLinClrLst/>
    <dgm:txFillClrLst/>
    <dgm:txEffectClrLst/>
  </dgm:styleLbl>
  <dgm:styleLbl name="ln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4">
        <a:alpha val="50000"/>
      </a:schemeClr>
      <a:schemeClr val="accent5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4">
        <a:tint val="50000"/>
      </a:schemeClr>
      <a:schemeClr val="accent5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4"/>
      <a:schemeClr val="accent5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>
        <a:tint val="9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>
        <a:tint val="5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colorful4">
  <dgm:title val=""/>
  <dgm:desc val=""/>
  <dgm:catLst>
    <dgm:cat type="colorful" pri="10400"/>
  </dgm:catLst>
  <dgm:styleLbl name="node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4"/>
      <a:schemeClr val="accent5"/>
    </dgm:fillClrLst>
    <dgm:linClrLst>
      <a:schemeClr val="accent4"/>
      <a:schemeClr val="accent5"/>
    </dgm:linClrLst>
    <dgm:effectClrLst/>
    <dgm:txLinClrLst/>
    <dgm:txFillClrLst/>
    <dgm:txEffectClrLst/>
  </dgm:styleLbl>
  <dgm:styleLbl name="lnNode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4">
        <a:alpha val="50000"/>
      </a:schemeClr>
      <a:schemeClr val="accent5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4">
        <a:tint val="50000"/>
      </a:schemeClr>
      <a:schemeClr val="accent5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4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4"/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4"/>
      <a:schemeClr val="accent5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4"/>
    </dgm:fillClrLst>
    <dgm:linClrLst meth="repeat">
      <a:schemeClr val="accent4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4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4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4"/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4">
        <a:tint val="90000"/>
      </a:schemeClr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4">
        <a:tint val="5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4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4"/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4">
        <a:tint val="40000"/>
        <a:alpha val="90000"/>
      </a:schemeClr>
      <a:schemeClr val="accent5">
        <a:tint val="40000"/>
        <a:alpha val="90000"/>
      </a:schemeClr>
    </dgm:fillClrLst>
    <dgm:linClrLst>
      <a:schemeClr val="accent4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5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4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4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4">
        <a:tint val="50000"/>
        <a:alpha val="40000"/>
      </a:schemeClr>
    </dgm:fillClrLst>
    <dgm:linClrLst meth="repeat">
      <a:schemeClr val="accent4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4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FE92A7ED-4704-4940-9F3B-CEB13A669BF0}" type="doc">
      <dgm:prSet loTypeId="urn:microsoft.com/office/officeart/2005/8/layout/process1" loCatId="process" qsTypeId="urn:microsoft.com/office/officeart/2005/8/quickstyle/simple1" qsCatId="simple" csTypeId="urn:microsoft.com/office/officeart/2005/8/colors/colorful4" csCatId="colorful" phldr="1"/>
      <dgm:spPr/>
      <dgm:t>
        <a:bodyPr/>
        <a:lstStyle/>
        <a:p>
          <a:pPr latinLnBrk="1"/>
          <a:endParaRPr lang="ko-KR" altLang="en-US"/>
        </a:p>
      </dgm:t>
    </dgm:pt>
    <dgm:pt modelId="{584372B1-730E-4FC3-A818-2E1272442E77}">
      <dgm:prSet phldrT="[텍스트]" custT="1"/>
      <dgm:spPr/>
      <dgm:t>
        <a:bodyPr/>
        <a:lstStyle/>
        <a:p>
          <a:pPr latinLnBrk="1">
            <a:lnSpc>
              <a:spcPct val="100000"/>
            </a:lnSpc>
          </a:pPr>
          <a:r>
            <a:rPr lang="en-US" sz="2000" b="1" i="0"/>
            <a:t>Sample</a:t>
          </a:r>
          <a:br>
            <a:rPr lang="en-US" sz="2000" b="1"/>
          </a:br>
          <a:r>
            <a:rPr lang="en-US" sz="2000" b="1" i="0"/>
            <a:t>Design</a:t>
          </a:r>
          <a:endParaRPr lang="ko-KR" altLang="en-US" sz="2000" b="1">
            <a:effectLst>
              <a:outerShdw blurRad="38100" dist="38100" dir="2700000" algn="tl">
                <a:srgbClr val="000000">
                  <a:alpha val="43137"/>
                </a:srgbClr>
              </a:outerShdw>
            </a:effectLst>
          </a:endParaRPr>
        </a:p>
      </dgm:t>
    </dgm:pt>
    <dgm:pt modelId="{90867284-606A-4E3D-9DF8-DDE0CB9E147A}" type="parTrans" cxnId="{DF48C12C-7795-4E49-9AA9-FC9096C4439C}">
      <dgm:prSet/>
      <dgm:spPr/>
      <dgm:t>
        <a:bodyPr/>
        <a:lstStyle/>
        <a:p>
          <a:pPr latinLnBrk="1"/>
          <a:endParaRPr lang="ko-KR" altLang="en-US"/>
        </a:p>
      </dgm:t>
    </dgm:pt>
    <dgm:pt modelId="{3113B7D6-B0A5-4D31-B67F-C0EC65E44226}" type="sibTrans" cxnId="{DF48C12C-7795-4E49-9AA9-FC9096C4439C}">
      <dgm:prSet/>
      <dgm:spPr/>
      <dgm:t>
        <a:bodyPr/>
        <a:lstStyle/>
        <a:p>
          <a:pPr latinLnBrk="1"/>
          <a:endParaRPr lang="ko-KR" altLang="en-US"/>
        </a:p>
      </dgm:t>
    </dgm:pt>
    <dgm:pt modelId="{097446BD-7F60-4509-9B77-7159CC084FB0}">
      <dgm:prSet phldrT="[텍스트]" custT="1"/>
      <dgm:spPr/>
      <dgm:t>
        <a:bodyPr/>
        <a:lstStyle/>
        <a:p>
          <a:pPr latinLnBrk="1">
            <a:lnSpc>
              <a:spcPct val="100000"/>
            </a:lnSpc>
          </a:pPr>
          <a:r>
            <a:rPr lang="en-US" sz="2000" b="1" i="0" dirty="0"/>
            <a:t>Participant</a:t>
          </a:r>
          <a:br>
            <a:rPr lang="en-US" sz="2000" b="1" dirty="0"/>
          </a:br>
          <a:r>
            <a:rPr lang="en-US" sz="2000" b="1" dirty="0"/>
            <a:t>Recruitment</a:t>
          </a:r>
          <a:endParaRPr lang="ko-KR" altLang="en-US" sz="2000" b="1" dirty="0">
            <a:effectLst/>
          </a:endParaRPr>
        </a:p>
      </dgm:t>
    </dgm:pt>
    <dgm:pt modelId="{6C37AF07-6B1B-46D8-B204-E7EBCB669411}" type="parTrans" cxnId="{A5EFE70E-EF0D-4551-9293-DF7A1F10D7CE}">
      <dgm:prSet/>
      <dgm:spPr/>
      <dgm:t>
        <a:bodyPr/>
        <a:lstStyle/>
        <a:p>
          <a:pPr latinLnBrk="1"/>
          <a:endParaRPr lang="ko-KR" altLang="en-US"/>
        </a:p>
      </dgm:t>
    </dgm:pt>
    <dgm:pt modelId="{0BFEC525-8ECD-4051-83F6-F1FA3CD659F1}" type="sibTrans" cxnId="{A5EFE70E-EF0D-4551-9293-DF7A1F10D7CE}">
      <dgm:prSet/>
      <dgm:spPr/>
      <dgm:t>
        <a:bodyPr/>
        <a:lstStyle/>
        <a:p>
          <a:pPr latinLnBrk="1"/>
          <a:endParaRPr lang="ko-KR" altLang="en-US"/>
        </a:p>
      </dgm:t>
    </dgm:pt>
    <dgm:pt modelId="{F0EFC7C1-5C7E-4C5F-9446-62A6E356FF8C}">
      <dgm:prSet phldrT="[텍스트]" custT="1"/>
      <dgm:spPr/>
      <dgm:t>
        <a:bodyPr/>
        <a:lstStyle/>
        <a:p>
          <a:pPr latinLnBrk="1">
            <a:lnSpc>
              <a:spcPct val="100000"/>
            </a:lnSpc>
          </a:pPr>
          <a:r>
            <a:rPr lang="en-US" sz="2000" b="1" i="0"/>
            <a:t>Biospecimen</a:t>
          </a:r>
          <a:br>
            <a:rPr lang="en-US" sz="2000"/>
          </a:br>
          <a:r>
            <a:rPr lang="en-US" sz="2000" b="1" i="0"/>
            <a:t>Collection</a:t>
          </a:r>
          <a:endParaRPr lang="ko-KR" altLang="en-US" sz="2000"/>
        </a:p>
      </dgm:t>
    </dgm:pt>
    <dgm:pt modelId="{8B73CF3B-E4E9-48FE-A5BC-295E89DB2AAC}" type="parTrans" cxnId="{F10850A8-FE02-4246-85EC-3A6C296F1744}">
      <dgm:prSet/>
      <dgm:spPr/>
      <dgm:t>
        <a:bodyPr/>
        <a:lstStyle/>
        <a:p>
          <a:pPr latinLnBrk="1"/>
          <a:endParaRPr lang="ko-KR" altLang="en-US"/>
        </a:p>
      </dgm:t>
    </dgm:pt>
    <dgm:pt modelId="{F0F49110-18F7-499B-BC6F-1AFC4B715C48}" type="sibTrans" cxnId="{F10850A8-FE02-4246-85EC-3A6C296F1744}">
      <dgm:prSet/>
      <dgm:spPr/>
      <dgm:t>
        <a:bodyPr/>
        <a:lstStyle/>
        <a:p>
          <a:pPr latinLnBrk="1"/>
          <a:endParaRPr lang="ko-KR" altLang="en-US"/>
        </a:p>
      </dgm:t>
    </dgm:pt>
    <dgm:pt modelId="{8E97041E-6F73-4F11-AE75-C6725436979C}">
      <dgm:prSet phldrT="[텍스트]" custT="1"/>
      <dgm:spPr/>
      <dgm:t>
        <a:bodyPr/>
        <a:lstStyle/>
        <a:p>
          <a:pPr latinLnBrk="1">
            <a:lnSpc>
              <a:spcPct val="100000"/>
            </a:lnSpc>
          </a:pPr>
          <a:r>
            <a:rPr lang="en-US" sz="2000" b="1" i="0"/>
            <a:t>Biobanking</a:t>
          </a:r>
          <a:endParaRPr lang="ko-KR" altLang="en-US" sz="2000"/>
        </a:p>
      </dgm:t>
    </dgm:pt>
    <dgm:pt modelId="{BC3B4A1F-FEC3-4BAD-8F56-5C95A7DACEC1}" type="parTrans" cxnId="{F8D5B0EA-A792-4713-BC66-972174853507}">
      <dgm:prSet/>
      <dgm:spPr/>
      <dgm:t>
        <a:bodyPr/>
        <a:lstStyle/>
        <a:p>
          <a:pPr latinLnBrk="1"/>
          <a:endParaRPr lang="ko-KR" altLang="en-US"/>
        </a:p>
      </dgm:t>
    </dgm:pt>
    <dgm:pt modelId="{3509087D-0553-42A1-B315-12A6E924E210}" type="sibTrans" cxnId="{F8D5B0EA-A792-4713-BC66-972174853507}">
      <dgm:prSet/>
      <dgm:spPr/>
      <dgm:t>
        <a:bodyPr/>
        <a:lstStyle/>
        <a:p>
          <a:pPr latinLnBrk="1"/>
          <a:endParaRPr lang="ko-KR" altLang="en-US"/>
        </a:p>
      </dgm:t>
    </dgm:pt>
    <dgm:pt modelId="{32B1F3CF-08AB-48A3-88FA-9D6711170EDB}">
      <dgm:prSet phldrT="[텍스트]" custT="1"/>
      <dgm:spPr/>
      <dgm:t>
        <a:bodyPr/>
        <a:lstStyle/>
        <a:p>
          <a:pPr latinLnBrk="1"/>
          <a:r>
            <a:rPr lang="en-US" sz="2000" b="1" i="0"/>
            <a:t>Analysis</a:t>
          </a:r>
          <a:endParaRPr lang="ko-KR" altLang="en-US" sz="2000"/>
        </a:p>
      </dgm:t>
    </dgm:pt>
    <dgm:pt modelId="{8C047A25-F184-42DF-8A97-AE629B19DBC5}" type="parTrans" cxnId="{FA1F68BB-52FC-4E9D-B00D-2D0CC7C4BD90}">
      <dgm:prSet/>
      <dgm:spPr/>
      <dgm:t>
        <a:bodyPr/>
        <a:lstStyle/>
        <a:p>
          <a:pPr latinLnBrk="1"/>
          <a:endParaRPr lang="ko-KR" altLang="en-US"/>
        </a:p>
      </dgm:t>
    </dgm:pt>
    <dgm:pt modelId="{56E1D483-D3F4-48C9-A32F-AF60AD32CF67}" type="sibTrans" cxnId="{FA1F68BB-52FC-4E9D-B00D-2D0CC7C4BD90}">
      <dgm:prSet/>
      <dgm:spPr/>
      <dgm:t>
        <a:bodyPr/>
        <a:lstStyle/>
        <a:p>
          <a:pPr latinLnBrk="1"/>
          <a:endParaRPr lang="ko-KR" altLang="en-US"/>
        </a:p>
      </dgm:t>
    </dgm:pt>
    <dgm:pt modelId="{3484058D-ADEC-4C4A-B577-617CA1DF13FB}" type="pres">
      <dgm:prSet presAssocID="{FE92A7ED-4704-4940-9F3B-CEB13A669BF0}" presName="Name0" presStyleCnt="0">
        <dgm:presLayoutVars>
          <dgm:dir/>
          <dgm:resizeHandles val="exact"/>
        </dgm:presLayoutVars>
      </dgm:prSet>
      <dgm:spPr/>
    </dgm:pt>
    <dgm:pt modelId="{B736850D-13E1-44BA-A7FF-5D79482DD661}" type="pres">
      <dgm:prSet presAssocID="{584372B1-730E-4FC3-A818-2E1272442E77}" presName="node" presStyleLbl="node1" presStyleIdx="0" presStyleCnt="5">
        <dgm:presLayoutVars>
          <dgm:bulletEnabled val="1"/>
        </dgm:presLayoutVars>
      </dgm:prSet>
      <dgm:spPr/>
    </dgm:pt>
    <dgm:pt modelId="{8AE4F5E3-D38A-456C-A107-A4366B2EB282}" type="pres">
      <dgm:prSet presAssocID="{3113B7D6-B0A5-4D31-B67F-C0EC65E44226}" presName="sibTrans" presStyleLbl="sibTrans2D1" presStyleIdx="0" presStyleCnt="4"/>
      <dgm:spPr/>
    </dgm:pt>
    <dgm:pt modelId="{8369832C-DB30-4175-975B-3595DA2CA434}" type="pres">
      <dgm:prSet presAssocID="{3113B7D6-B0A5-4D31-B67F-C0EC65E44226}" presName="connectorText" presStyleLbl="sibTrans2D1" presStyleIdx="0" presStyleCnt="4"/>
      <dgm:spPr/>
    </dgm:pt>
    <dgm:pt modelId="{DD7AE674-9303-4A8C-8937-7B1A4860ACFB}" type="pres">
      <dgm:prSet presAssocID="{097446BD-7F60-4509-9B77-7159CC084FB0}" presName="node" presStyleLbl="node1" presStyleIdx="1" presStyleCnt="5" custScaleX="117462">
        <dgm:presLayoutVars>
          <dgm:bulletEnabled val="1"/>
        </dgm:presLayoutVars>
      </dgm:prSet>
      <dgm:spPr/>
    </dgm:pt>
    <dgm:pt modelId="{7E5BE933-CA4F-48F4-B0DE-5D6C2675F8A9}" type="pres">
      <dgm:prSet presAssocID="{0BFEC525-8ECD-4051-83F6-F1FA3CD659F1}" presName="sibTrans" presStyleLbl="sibTrans2D1" presStyleIdx="1" presStyleCnt="4"/>
      <dgm:spPr/>
    </dgm:pt>
    <dgm:pt modelId="{C48C0697-70CE-472B-B91F-DB9EB0340D4F}" type="pres">
      <dgm:prSet presAssocID="{0BFEC525-8ECD-4051-83F6-F1FA3CD659F1}" presName="connectorText" presStyleLbl="sibTrans2D1" presStyleIdx="1" presStyleCnt="4"/>
      <dgm:spPr/>
    </dgm:pt>
    <dgm:pt modelId="{0A4AFA31-27D5-4E22-80AF-B135813D6558}" type="pres">
      <dgm:prSet presAssocID="{F0EFC7C1-5C7E-4C5F-9446-62A6E356FF8C}" presName="node" presStyleLbl="node1" presStyleIdx="2" presStyleCnt="5" custScaleX="124606">
        <dgm:presLayoutVars>
          <dgm:bulletEnabled val="1"/>
        </dgm:presLayoutVars>
      </dgm:prSet>
      <dgm:spPr/>
    </dgm:pt>
    <dgm:pt modelId="{23CFA9F2-E9AB-479E-8E9D-BFCA975C186E}" type="pres">
      <dgm:prSet presAssocID="{F0F49110-18F7-499B-BC6F-1AFC4B715C48}" presName="sibTrans" presStyleLbl="sibTrans2D1" presStyleIdx="2" presStyleCnt="4"/>
      <dgm:spPr/>
    </dgm:pt>
    <dgm:pt modelId="{23501E2B-0D45-46D2-A5D7-7D0C779BE4EB}" type="pres">
      <dgm:prSet presAssocID="{F0F49110-18F7-499B-BC6F-1AFC4B715C48}" presName="connectorText" presStyleLbl="sibTrans2D1" presStyleIdx="2" presStyleCnt="4"/>
      <dgm:spPr/>
    </dgm:pt>
    <dgm:pt modelId="{398BAFD7-08AA-400F-9B60-205203687C35}" type="pres">
      <dgm:prSet presAssocID="{32B1F3CF-08AB-48A3-88FA-9D6711170EDB}" presName="node" presStyleLbl="node1" presStyleIdx="3" presStyleCnt="5">
        <dgm:presLayoutVars>
          <dgm:bulletEnabled val="1"/>
        </dgm:presLayoutVars>
      </dgm:prSet>
      <dgm:spPr/>
    </dgm:pt>
    <dgm:pt modelId="{9D566990-796D-4483-9401-D242769EAF0C}" type="pres">
      <dgm:prSet presAssocID="{56E1D483-D3F4-48C9-A32F-AF60AD32CF67}" presName="sibTrans" presStyleLbl="sibTrans2D1" presStyleIdx="3" presStyleCnt="4"/>
      <dgm:spPr/>
    </dgm:pt>
    <dgm:pt modelId="{2E513A93-CE59-48CD-AA98-667103B65872}" type="pres">
      <dgm:prSet presAssocID="{56E1D483-D3F4-48C9-A32F-AF60AD32CF67}" presName="connectorText" presStyleLbl="sibTrans2D1" presStyleIdx="3" presStyleCnt="4"/>
      <dgm:spPr/>
    </dgm:pt>
    <dgm:pt modelId="{6A429B86-4A60-49DA-AB8D-00BB6EB1C7F0}" type="pres">
      <dgm:prSet presAssocID="{8E97041E-6F73-4F11-AE75-C6725436979C}" presName="node" presStyleLbl="node1" presStyleIdx="4" presStyleCnt="5" custScaleX="116224" custLinFactNeighborX="-5524" custLinFactNeighborY="-1339">
        <dgm:presLayoutVars>
          <dgm:bulletEnabled val="1"/>
        </dgm:presLayoutVars>
      </dgm:prSet>
      <dgm:spPr/>
    </dgm:pt>
  </dgm:ptLst>
  <dgm:cxnLst>
    <dgm:cxn modelId="{A5EFE70E-EF0D-4551-9293-DF7A1F10D7CE}" srcId="{FE92A7ED-4704-4940-9F3B-CEB13A669BF0}" destId="{097446BD-7F60-4509-9B77-7159CC084FB0}" srcOrd="1" destOrd="0" parTransId="{6C37AF07-6B1B-46D8-B204-E7EBCB669411}" sibTransId="{0BFEC525-8ECD-4051-83F6-F1FA3CD659F1}"/>
    <dgm:cxn modelId="{BB542522-649B-4D1E-B2ED-E73711D573F8}" type="presOf" srcId="{32B1F3CF-08AB-48A3-88FA-9D6711170EDB}" destId="{398BAFD7-08AA-400F-9B60-205203687C35}" srcOrd="0" destOrd="0" presId="urn:microsoft.com/office/officeart/2005/8/layout/process1"/>
    <dgm:cxn modelId="{9B49B329-EA5D-4EE4-BF46-D7DA857F2F41}" type="presOf" srcId="{F0F49110-18F7-499B-BC6F-1AFC4B715C48}" destId="{23CFA9F2-E9AB-479E-8E9D-BFCA975C186E}" srcOrd="0" destOrd="0" presId="urn:microsoft.com/office/officeart/2005/8/layout/process1"/>
    <dgm:cxn modelId="{E8FD2F2B-C0A3-4026-AF8A-BF36D5A34FB8}" type="presOf" srcId="{56E1D483-D3F4-48C9-A32F-AF60AD32CF67}" destId="{9D566990-796D-4483-9401-D242769EAF0C}" srcOrd="0" destOrd="0" presId="urn:microsoft.com/office/officeart/2005/8/layout/process1"/>
    <dgm:cxn modelId="{DF48C12C-7795-4E49-9AA9-FC9096C4439C}" srcId="{FE92A7ED-4704-4940-9F3B-CEB13A669BF0}" destId="{584372B1-730E-4FC3-A818-2E1272442E77}" srcOrd="0" destOrd="0" parTransId="{90867284-606A-4E3D-9DF8-DDE0CB9E147A}" sibTransId="{3113B7D6-B0A5-4D31-B67F-C0EC65E44226}"/>
    <dgm:cxn modelId="{305B395F-8BD5-41BE-8A01-8103AB057A2C}" type="presOf" srcId="{F0EFC7C1-5C7E-4C5F-9446-62A6E356FF8C}" destId="{0A4AFA31-27D5-4E22-80AF-B135813D6558}" srcOrd="0" destOrd="0" presId="urn:microsoft.com/office/officeart/2005/8/layout/process1"/>
    <dgm:cxn modelId="{B0563B61-2DFC-45AC-B2A1-7FFD21B8D6E1}" type="presOf" srcId="{0BFEC525-8ECD-4051-83F6-F1FA3CD659F1}" destId="{C48C0697-70CE-472B-B91F-DB9EB0340D4F}" srcOrd="1" destOrd="0" presId="urn:microsoft.com/office/officeart/2005/8/layout/process1"/>
    <dgm:cxn modelId="{C11EB848-9A76-41C8-B182-D2F4E9E11271}" type="presOf" srcId="{584372B1-730E-4FC3-A818-2E1272442E77}" destId="{B736850D-13E1-44BA-A7FF-5D79482DD661}" srcOrd="0" destOrd="0" presId="urn:microsoft.com/office/officeart/2005/8/layout/process1"/>
    <dgm:cxn modelId="{A6FCD74C-B695-4448-A8A0-CD85E2E4A519}" type="presOf" srcId="{56E1D483-D3F4-48C9-A32F-AF60AD32CF67}" destId="{2E513A93-CE59-48CD-AA98-667103B65872}" srcOrd="1" destOrd="0" presId="urn:microsoft.com/office/officeart/2005/8/layout/process1"/>
    <dgm:cxn modelId="{4690654D-3FBF-4760-9F5D-5ADFACC91157}" type="presOf" srcId="{3113B7D6-B0A5-4D31-B67F-C0EC65E44226}" destId="{8369832C-DB30-4175-975B-3595DA2CA434}" srcOrd="1" destOrd="0" presId="urn:microsoft.com/office/officeart/2005/8/layout/process1"/>
    <dgm:cxn modelId="{772A378D-27CC-4558-9918-BEE2D165A8CF}" type="presOf" srcId="{0BFEC525-8ECD-4051-83F6-F1FA3CD659F1}" destId="{7E5BE933-CA4F-48F4-B0DE-5D6C2675F8A9}" srcOrd="0" destOrd="0" presId="urn:microsoft.com/office/officeart/2005/8/layout/process1"/>
    <dgm:cxn modelId="{F10850A8-FE02-4246-85EC-3A6C296F1744}" srcId="{FE92A7ED-4704-4940-9F3B-CEB13A669BF0}" destId="{F0EFC7C1-5C7E-4C5F-9446-62A6E356FF8C}" srcOrd="2" destOrd="0" parTransId="{8B73CF3B-E4E9-48FE-A5BC-295E89DB2AAC}" sibTransId="{F0F49110-18F7-499B-BC6F-1AFC4B715C48}"/>
    <dgm:cxn modelId="{1F921BB4-382F-45C6-A746-906F36F92F1E}" type="presOf" srcId="{8E97041E-6F73-4F11-AE75-C6725436979C}" destId="{6A429B86-4A60-49DA-AB8D-00BB6EB1C7F0}" srcOrd="0" destOrd="0" presId="urn:microsoft.com/office/officeart/2005/8/layout/process1"/>
    <dgm:cxn modelId="{FA1F68BB-52FC-4E9D-B00D-2D0CC7C4BD90}" srcId="{FE92A7ED-4704-4940-9F3B-CEB13A669BF0}" destId="{32B1F3CF-08AB-48A3-88FA-9D6711170EDB}" srcOrd="3" destOrd="0" parTransId="{8C047A25-F184-42DF-8A97-AE629B19DBC5}" sibTransId="{56E1D483-D3F4-48C9-A32F-AF60AD32CF67}"/>
    <dgm:cxn modelId="{D10B64D3-2DC2-4429-8F3A-A4104F5E0C9D}" type="presOf" srcId="{FE92A7ED-4704-4940-9F3B-CEB13A669BF0}" destId="{3484058D-ADEC-4C4A-B577-617CA1DF13FB}" srcOrd="0" destOrd="0" presId="urn:microsoft.com/office/officeart/2005/8/layout/process1"/>
    <dgm:cxn modelId="{9F1BD8D4-B536-49FB-B596-57B952594767}" type="presOf" srcId="{3113B7D6-B0A5-4D31-B67F-C0EC65E44226}" destId="{8AE4F5E3-D38A-456C-A107-A4366B2EB282}" srcOrd="0" destOrd="0" presId="urn:microsoft.com/office/officeart/2005/8/layout/process1"/>
    <dgm:cxn modelId="{F7FD22E8-FBFE-4138-A974-600ADB62368C}" type="presOf" srcId="{F0F49110-18F7-499B-BC6F-1AFC4B715C48}" destId="{23501E2B-0D45-46D2-A5D7-7D0C779BE4EB}" srcOrd="1" destOrd="0" presId="urn:microsoft.com/office/officeart/2005/8/layout/process1"/>
    <dgm:cxn modelId="{431635E9-84B5-4F7D-AFA6-B43BF29FDA1C}" type="presOf" srcId="{097446BD-7F60-4509-9B77-7159CC084FB0}" destId="{DD7AE674-9303-4A8C-8937-7B1A4860ACFB}" srcOrd="0" destOrd="0" presId="urn:microsoft.com/office/officeart/2005/8/layout/process1"/>
    <dgm:cxn modelId="{F8D5B0EA-A792-4713-BC66-972174853507}" srcId="{FE92A7ED-4704-4940-9F3B-CEB13A669BF0}" destId="{8E97041E-6F73-4F11-AE75-C6725436979C}" srcOrd="4" destOrd="0" parTransId="{BC3B4A1F-FEC3-4BAD-8F56-5C95A7DACEC1}" sibTransId="{3509087D-0553-42A1-B315-12A6E924E210}"/>
    <dgm:cxn modelId="{A14C2F4B-A971-4D12-95AA-D69B304B61CC}" type="presParOf" srcId="{3484058D-ADEC-4C4A-B577-617CA1DF13FB}" destId="{B736850D-13E1-44BA-A7FF-5D79482DD661}" srcOrd="0" destOrd="0" presId="urn:microsoft.com/office/officeart/2005/8/layout/process1"/>
    <dgm:cxn modelId="{BB184CD9-0290-4733-A773-CCBD896D3293}" type="presParOf" srcId="{3484058D-ADEC-4C4A-B577-617CA1DF13FB}" destId="{8AE4F5E3-D38A-456C-A107-A4366B2EB282}" srcOrd="1" destOrd="0" presId="urn:microsoft.com/office/officeart/2005/8/layout/process1"/>
    <dgm:cxn modelId="{CBF0BE49-A598-43A8-9B27-95D5EF88FB8A}" type="presParOf" srcId="{8AE4F5E3-D38A-456C-A107-A4366B2EB282}" destId="{8369832C-DB30-4175-975B-3595DA2CA434}" srcOrd="0" destOrd="0" presId="urn:microsoft.com/office/officeart/2005/8/layout/process1"/>
    <dgm:cxn modelId="{728FD261-4374-4306-9F7E-7BF0BE1BF94E}" type="presParOf" srcId="{3484058D-ADEC-4C4A-B577-617CA1DF13FB}" destId="{DD7AE674-9303-4A8C-8937-7B1A4860ACFB}" srcOrd="2" destOrd="0" presId="urn:microsoft.com/office/officeart/2005/8/layout/process1"/>
    <dgm:cxn modelId="{CA08F22C-D93F-4B48-A75D-E7EB57D68F82}" type="presParOf" srcId="{3484058D-ADEC-4C4A-B577-617CA1DF13FB}" destId="{7E5BE933-CA4F-48F4-B0DE-5D6C2675F8A9}" srcOrd="3" destOrd="0" presId="urn:microsoft.com/office/officeart/2005/8/layout/process1"/>
    <dgm:cxn modelId="{917CDCF1-92ED-4692-9E64-D575990F6BC7}" type="presParOf" srcId="{7E5BE933-CA4F-48F4-B0DE-5D6C2675F8A9}" destId="{C48C0697-70CE-472B-B91F-DB9EB0340D4F}" srcOrd="0" destOrd="0" presId="urn:microsoft.com/office/officeart/2005/8/layout/process1"/>
    <dgm:cxn modelId="{7D9AD2EC-F10B-4930-9673-867A336135E9}" type="presParOf" srcId="{3484058D-ADEC-4C4A-B577-617CA1DF13FB}" destId="{0A4AFA31-27D5-4E22-80AF-B135813D6558}" srcOrd="4" destOrd="0" presId="urn:microsoft.com/office/officeart/2005/8/layout/process1"/>
    <dgm:cxn modelId="{1BC45795-C505-4264-B744-C7D8FAA681A7}" type="presParOf" srcId="{3484058D-ADEC-4C4A-B577-617CA1DF13FB}" destId="{23CFA9F2-E9AB-479E-8E9D-BFCA975C186E}" srcOrd="5" destOrd="0" presId="urn:microsoft.com/office/officeart/2005/8/layout/process1"/>
    <dgm:cxn modelId="{B471107B-C7A5-4FCF-899A-1CBEACE6E84C}" type="presParOf" srcId="{23CFA9F2-E9AB-479E-8E9D-BFCA975C186E}" destId="{23501E2B-0D45-46D2-A5D7-7D0C779BE4EB}" srcOrd="0" destOrd="0" presId="urn:microsoft.com/office/officeart/2005/8/layout/process1"/>
    <dgm:cxn modelId="{076CE549-1471-48FB-AE0B-C25A5C1012CE}" type="presParOf" srcId="{3484058D-ADEC-4C4A-B577-617CA1DF13FB}" destId="{398BAFD7-08AA-400F-9B60-205203687C35}" srcOrd="6" destOrd="0" presId="urn:microsoft.com/office/officeart/2005/8/layout/process1"/>
    <dgm:cxn modelId="{8D5AA5A2-975E-4A78-A0BB-ED6408093AFA}" type="presParOf" srcId="{3484058D-ADEC-4C4A-B577-617CA1DF13FB}" destId="{9D566990-796D-4483-9401-D242769EAF0C}" srcOrd="7" destOrd="0" presId="urn:microsoft.com/office/officeart/2005/8/layout/process1"/>
    <dgm:cxn modelId="{5C4BDC76-AB69-4873-BAA0-6502B69B841E}" type="presParOf" srcId="{9D566990-796D-4483-9401-D242769EAF0C}" destId="{2E513A93-CE59-48CD-AA98-667103B65872}" srcOrd="0" destOrd="0" presId="urn:microsoft.com/office/officeart/2005/8/layout/process1"/>
    <dgm:cxn modelId="{2D54108C-9056-4750-86DF-4ABDD548DCFB}" type="presParOf" srcId="{3484058D-ADEC-4C4A-B577-617CA1DF13FB}" destId="{6A429B86-4A60-49DA-AB8D-00BB6EB1C7F0}" srcOrd="8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FE92A7ED-4704-4940-9F3B-CEB13A669BF0}" type="doc">
      <dgm:prSet loTypeId="urn:microsoft.com/office/officeart/2005/8/layout/process1" loCatId="process" qsTypeId="urn:microsoft.com/office/officeart/2005/8/quickstyle/simple1" qsCatId="simple" csTypeId="urn:microsoft.com/office/officeart/2005/8/colors/colorful4" csCatId="colorful" phldr="1"/>
      <dgm:spPr/>
      <dgm:t>
        <a:bodyPr/>
        <a:lstStyle/>
        <a:p>
          <a:pPr latinLnBrk="1"/>
          <a:endParaRPr lang="ko-KR" altLang="en-US"/>
        </a:p>
      </dgm:t>
    </dgm:pt>
    <dgm:pt modelId="{584372B1-730E-4FC3-A818-2E1272442E77}">
      <dgm:prSet phldrT="[텍스트]" custT="1"/>
      <dgm:spPr/>
      <dgm:t>
        <a:bodyPr/>
        <a:lstStyle/>
        <a:p>
          <a:pPr latinLnBrk="1">
            <a:lnSpc>
              <a:spcPct val="100000"/>
            </a:lnSpc>
          </a:pPr>
          <a:r>
            <a:rPr lang="en-US" sz="2000" b="1" i="0"/>
            <a:t>Sample</a:t>
          </a:r>
          <a:br>
            <a:rPr lang="en-US" sz="2000" b="1"/>
          </a:br>
          <a:r>
            <a:rPr lang="en-US" sz="2000" b="1" i="0"/>
            <a:t>Design</a:t>
          </a:r>
          <a:endParaRPr lang="ko-KR" altLang="en-US" sz="2000" b="1">
            <a:effectLst>
              <a:outerShdw blurRad="38100" dist="38100" dir="2700000" algn="tl">
                <a:srgbClr val="000000">
                  <a:alpha val="43137"/>
                </a:srgbClr>
              </a:outerShdw>
            </a:effectLst>
          </a:endParaRPr>
        </a:p>
      </dgm:t>
    </dgm:pt>
    <dgm:pt modelId="{90867284-606A-4E3D-9DF8-DDE0CB9E147A}" type="parTrans" cxnId="{DF48C12C-7795-4E49-9AA9-FC9096C4439C}">
      <dgm:prSet/>
      <dgm:spPr/>
      <dgm:t>
        <a:bodyPr/>
        <a:lstStyle/>
        <a:p>
          <a:pPr latinLnBrk="1"/>
          <a:endParaRPr lang="ko-KR" altLang="en-US"/>
        </a:p>
      </dgm:t>
    </dgm:pt>
    <dgm:pt modelId="{3113B7D6-B0A5-4D31-B67F-C0EC65E44226}" type="sibTrans" cxnId="{DF48C12C-7795-4E49-9AA9-FC9096C4439C}">
      <dgm:prSet/>
      <dgm:spPr/>
      <dgm:t>
        <a:bodyPr/>
        <a:lstStyle/>
        <a:p>
          <a:pPr latinLnBrk="1"/>
          <a:endParaRPr lang="ko-KR" altLang="en-US"/>
        </a:p>
      </dgm:t>
    </dgm:pt>
    <dgm:pt modelId="{097446BD-7F60-4509-9B77-7159CC084FB0}">
      <dgm:prSet phldrT="[텍스트]" custT="1"/>
      <dgm:spPr/>
      <dgm:t>
        <a:bodyPr/>
        <a:lstStyle/>
        <a:p>
          <a:pPr latinLnBrk="1">
            <a:lnSpc>
              <a:spcPct val="100000"/>
            </a:lnSpc>
          </a:pPr>
          <a:r>
            <a:rPr lang="en-US" sz="2000" b="1" i="0" dirty="0"/>
            <a:t>Participant</a:t>
          </a:r>
          <a:br>
            <a:rPr lang="en-US" sz="2000" b="1" dirty="0"/>
          </a:br>
          <a:r>
            <a:rPr lang="en-US" sz="2000" b="1" dirty="0"/>
            <a:t>Recruitment</a:t>
          </a:r>
          <a:endParaRPr lang="ko-KR" altLang="en-US" sz="2000" b="1" dirty="0">
            <a:effectLst/>
          </a:endParaRPr>
        </a:p>
      </dgm:t>
    </dgm:pt>
    <dgm:pt modelId="{6C37AF07-6B1B-46D8-B204-E7EBCB669411}" type="parTrans" cxnId="{A5EFE70E-EF0D-4551-9293-DF7A1F10D7CE}">
      <dgm:prSet/>
      <dgm:spPr/>
      <dgm:t>
        <a:bodyPr/>
        <a:lstStyle/>
        <a:p>
          <a:pPr latinLnBrk="1"/>
          <a:endParaRPr lang="ko-KR" altLang="en-US"/>
        </a:p>
      </dgm:t>
    </dgm:pt>
    <dgm:pt modelId="{0BFEC525-8ECD-4051-83F6-F1FA3CD659F1}" type="sibTrans" cxnId="{A5EFE70E-EF0D-4551-9293-DF7A1F10D7CE}">
      <dgm:prSet/>
      <dgm:spPr/>
      <dgm:t>
        <a:bodyPr/>
        <a:lstStyle/>
        <a:p>
          <a:pPr latinLnBrk="1"/>
          <a:endParaRPr lang="ko-KR" altLang="en-US"/>
        </a:p>
      </dgm:t>
    </dgm:pt>
    <dgm:pt modelId="{F0EFC7C1-5C7E-4C5F-9446-62A6E356FF8C}">
      <dgm:prSet phldrT="[텍스트]" custT="1"/>
      <dgm:spPr/>
      <dgm:t>
        <a:bodyPr/>
        <a:lstStyle/>
        <a:p>
          <a:pPr latinLnBrk="1">
            <a:lnSpc>
              <a:spcPct val="100000"/>
            </a:lnSpc>
          </a:pPr>
          <a:r>
            <a:rPr lang="en-US" sz="2000" b="1" i="0"/>
            <a:t>Biospecimen</a:t>
          </a:r>
          <a:br>
            <a:rPr lang="en-US" sz="2000"/>
          </a:br>
          <a:r>
            <a:rPr lang="en-US" sz="2000" b="1" i="0"/>
            <a:t>Collection</a:t>
          </a:r>
          <a:endParaRPr lang="ko-KR" altLang="en-US" sz="2000"/>
        </a:p>
      </dgm:t>
    </dgm:pt>
    <dgm:pt modelId="{8B73CF3B-E4E9-48FE-A5BC-295E89DB2AAC}" type="parTrans" cxnId="{F10850A8-FE02-4246-85EC-3A6C296F1744}">
      <dgm:prSet/>
      <dgm:spPr/>
      <dgm:t>
        <a:bodyPr/>
        <a:lstStyle/>
        <a:p>
          <a:pPr latinLnBrk="1"/>
          <a:endParaRPr lang="ko-KR" altLang="en-US"/>
        </a:p>
      </dgm:t>
    </dgm:pt>
    <dgm:pt modelId="{F0F49110-18F7-499B-BC6F-1AFC4B715C48}" type="sibTrans" cxnId="{F10850A8-FE02-4246-85EC-3A6C296F1744}">
      <dgm:prSet/>
      <dgm:spPr/>
      <dgm:t>
        <a:bodyPr/>
        <a:lstStyle/>
        <a:p>
          <a:pPr latinLnBrk="1"/>
          <a:endParaRPr lang="ko-KR" altLang="en-US"/>
        </a:p>
      </dgm:t>
    </dgm:pt>
    <dgm:pt modelId="{8E97041E-6F73-4F11-AE75-C6725436979C}">
      <dgm:prSet phldrT="[텍스트]" custT="1"/>
      <dgm:spPr/>
      <dgm:t>
        <a:bodyPr/>
        <a:lstStyle/>
        <a:p>
          <a:pPr latinLnBrk="1">
            <a:lnSpc>
              <a:spcPct val="100000"/>
            </a:lnSpc>
          </a:pPr>
          <a:r>
            <a:rPr lang="en-US" sz="2000" b="1" i="0"/>
            <a:t>Biobanking</a:t>
          </a:r>
          <a:endParaRPr lang="ko-KR" altLang="en-US" sz="2000"/>
        </a:p>
      </dgm:t>
    </dgm:pt>
    <dgm:pt modelId="{BC3B4A1F-FEC3-4BAD-8F56-5C95A7DACEC1}" type="parTrans" cxnId="{F8D5B0EA-A792-4713-BC66-972174853507}">
      <dgm:prSet/>
      <dgm:spPr/>
      <dgm:t>
        <a:bodyPr/>
        <a:lstStyle/>
        <a:p>
          <a:pPr latinLnBrk="1"/>
          <a:endParaRPr lang="ko-KR" altLang="en-US"/>
        </a:p>
      </dgm:t>
    </dgm:pt>
    <dgm:pt modelId="{3509087D-0553-42A1-B315-12A6E924E210}" type="sibTrans" cxnId="{F8D5B0EA-A792-4713-BC66-972174853507}">
      <dgm:prSet/>
      <dgm:spPr/>
      <dgm:t>
        <a:bodyPr/>
        <a:lstStyle/>
        <a:p>
          <a:pPr latinLnBrk="1"/>
          <a:endParaRPr lang="ko-KR" altLang="en-US"/>
        </a:p>
      </dgm:t>
    </dgm:pt>
    <dgm:pt modelId="{32B1F3CF-08AB-48A3-88FA-9D6711170EDB}">
      <dgm:prSet phldrT="[텍스트]" custT="1"/>
      <dgm:spPr/>
      <dgm:t>
        <a:bodyPr/>
        <a:lstStyle/>
        <a:p>
          <a:pPr latinLnBrk="1"/>
          <a:r>
            <a:rPr lang="en-US" sz="2000" b="1" i="0"/>
            <a:t>Analysis</a:t>
          </a:r>
          <a:endParaRPr lang="ko-KR" altLang="en-US" sz="2000"/>
        </a:p>
      </dgm:t>
    </dgm:pt>
    <dgm:pt modelId="{8C047A25-F184-42DF-8A97-AE629B19DBC5}" type="parTrans" cxnId="{FA1F68BB-52FC-4E9D-B00D-2D0CC7C4BD90}">
      <dgm:prSet/>
      <dgm:spPr/>
      <dgm:t>
        <a:bodyPr/>
        <a:lstStyle/>
        <a:p>
          <a:pPr latinLnBrk="1"/>
          <a:endParaRPr lang="ko-KR" altLang="en-US"/>
        </a:p>
      </dgm:t>
    </dgm:pt>
    <dgm:pt modelId="{56E1D483-D3F4-48C9-A32F-AF60AD32CF67}" type="sibTrans" cxnId="{FA1F68BB-52FC-4E9D-B00D-2D0CC7C4BD90}">
      <dgm:prSet/>
      <dgm:spPr/>
      <dgm:t>
        <a:bodyPr/>
        <a:lstStyle/>
        <a:p>
          <a:pPr latinLnBrk="1"/>
          <a:endParaRPr lang="ko-KR" altLang="en-US"/>
        </a:p>
      </dgm:t>
    </dgm:pt>
    <dgm:pt modelId="{3484058D-ADEC-4C4A-B577-617CA1DF13FB}" type="pres">
      <dgm:prSet presAssocID="{FE92A7ED-4704-4940-9F3B-CEB13A669BF0}" presName="Name0" presStyleCnt="0">
        <dgm:presLayoutVars>
          <dgm:dir/>
          <dgm:resizeHandles val="exact"/>
        </dgm:presLayoutVars>
      </dgm:prSet>
      <dgm:spPr/>
    </dgm:pt>
    <dgm:pt modelId="{B736850D-13E1-44BA-A7FF-5D79482DD661}" type="pres">
      <dgm:prSet presAssocID="{584372B1-730E-4FC3-A818-2E1272442E77}" presName="node" presStyleLbl="node1" presStyleIdx="0" presStyleCnt="5">
        <dgm:presLayoutVars>
          <dgm:bulletEnabled val="1"/>
        </dgm:presLayoutVars>
      </dgm:prSet>
      <dgm:spPr/>
    </dgm:pt>
    <dgm:pt modelId="{8AE4F5E3-D38A-456C-A107-A4366B2EB282}" type="pres">
      <dgm:prSet presAssocID="{3113B7D6-B0A5-4D31-B67F-C0EC65E44226}" presName="sibTrans" presStyleLbl="sibTrans2D1" presStyleIdx="0" presStyleCnt="4"/>
      <dgm:spPr/>
    </dgm:pt>
    <dgm:pt modelId="{8369832C-DB30-4175-975B-3595DA2CA434}" type="pres">
      <dgm:prSet presAssocID="{3113B7D6-B0A5-4D31-B67F-C0EC65E44226}" presName="connectorText" presStyleLbl="sibTrans2D1" presStyleIdx="0" presStyleCnt="4"/>
      <dgm:spPr/>
    </dgm:pt>
    <dgm:pt modelId="{DD7AE674-9303-4A8C-8937-7B1A4860ACFB}" type="pres">
      <dgm:prSet presAssocID="{097446BD-7F60-4509-9B77-7159CC084FB0}" presName="node" presStyleLbl="node1" presStyleIdx="1" presStyleCnt="5" custScaleX="117462">
        <dgm:presLayoutVars>
          <dgm:bulletEnabled val="1"/>
        </dgm:presLayoutVars>
      </dgm:prSet>
      <dgm:spPr/>
    </dgm:pt>
    <dgm:pt modelId="{7E5BE933-CA4F-48F4-B0DE-5D6C2675F8A9}" type="pres">
      <dgm:prSet presAssocID="{0BFEC525-8ECD-4051-83F6-F1FA3CD659F1}" presName="sibTrans" presStyleLbl="sibTrans2D1" presStyleIdx="1" presStyleCnt="4"/>
      <dgm:spPr/>
    </dgm:pt>
    <dgm:pt modelId="{C48C0697-70CE-472B-B91F-DB9EB0340D4F}" type="pres">
      <dgm:prSet presAssocID="{0BFEC525-8ECD-4051-83F6-F1FA3CD659F1}" presName="connectorText" presStyleLbl="sibTrans2D1" presStyleIdx="1" presStyleCnt="4"/>
      <dgm:spPr/>
    </dgm:pt>
    <dgm:pt modelId="{0A4AFA31-27D5-4E22-80AF-B135813D6558}" type="pres">
      <dgm:prSet presAssocID="{F0EFC7C1-5C7E-4C5F-9446-62A6E356FF8C}" presName="node" presStyleLbl="node1" presStyleIdx="2" presStyleCnt="5" custScaleX="124606">
        <dgm:presLayoutVars>
          <dgm:bulletEnabled val="1"/>
        </dgm:presLayoutVars>
      </dgm:prSet>
      <dgm:spPr/>
    </dgm:pt>
    <dgm:pt modelId="{23CFA9F2-E9AB-479E-8E9D-BFCA975C186E}" type="pres">
      <dgm:prSet presAssocID="{F0F49110-18F7-499B-BC6F-1AFC4B715C48}" presName="sibTrans" presStyleLbl="sibTrans2D1" presStyleIdx="2" presStyleCnt="4"/>
      <dgm:spPr/>
    </dgm:pt>
    <dgm:pt modelId="{23501E2B-0D45-46D2-A5D7-7D0C779BE4EB}" type="pres">
      <dgm:prSet presAssocID="{F0F49110-18F7-499B-BC6F-1AFC4B715C48}" presName="connectorText" presStyleLbl="sibTrans2D1" presStyleIdx="2" presStyleCnt="4"/>
      <dgm:spPr/>
    </dgm:pt>
    <dgm:pt modelId="{398BAFD7-08AA-400F-9B60-205203687C35}" type="pres">
      <dgm:prSet presAssocID="{32B1F3CF-08AB-48A3-88FA-9D6711170EDB}" presName="node" presStyleLbl="node1" presStyleIdx="3" presStyleCnt="5">
        <dgm:presLayoutVars>
          <dgm:bulletEnabled val="1"/>
        </dgm:presLayoutVars>
      </dgm:prSet>
      <dgm:spPr/>
    </dgm:pt>
    <dgm:pt modelId="{9D566990-796D-4483-9401-D242769EAF0C}" type="pres">
      <dgm:prSet presAssocID="{56E1D483-D3F4-48C9-A32F-AF60AD32CF67}" presName="sibTrans" presStyleLbl="sibTrans2D1" presStyleIdx="3" presStyleCnt="4"/>
      <dgm:spPr/>
    </dgm:pt>
    <dgm:pt modelId="{2E513A93-CE59-48CD-AA98-667103B65872}" type="pres">
      <dgm:prSet presAssocID="{56E1D483-D3F4-48C9-A32F-AF60AD32CF67}" presName="connectorText" presStyleLbl="sibTrans2D1" presStyleIdx="3" presStyleCnt="4"/>
      <dgm:spPr/>
    </dgm:pt>
    <dgm:pt modelId="{6A429B86-4A60-49DA-AB8D-00BB6EB1C7F0}" type="pres">
      <dgm:prSet presAssocID="{8E97041E-6F73-4F11-AE75-C6725436979C}" presName="node" presStyleLbl="node1" presStyleIdx="4" presStyleCnt="5" custScaleX="116224" custLinFactNeighborX="-5524" custLinFactNeighborY="-1339">
        <dgm:presLayoutVars>
          <dgm:bulletEnabled val="1"/>
        </dgm:presLayoutVars>
      </dgm:prSet>
      <dgm:spPr/>
    </dgm:pt>
  </dgm:ptLst>
  <dgm:cxnLst>
    <dgm:cxn modelId="{A5EFE70E-EF0D-4551-9293-DF7A1F10D7CE}" srcId="{FE92A7ED-4704-4940-9F3B-CEB13A669BF0}" destId="{097446BD-7F60-4509-9B77-7159CC084FB0}" srcOrd="1" destOrd="0" parTransId="{6C37AF07-6B1B-46D8-B204-E7EBCB669411}" sibTransId="{0BFEC525-8ECD-4051-83F6-F1FA3CD659F1}"/>
    <dgm:cxn modelId="{BB542522-649B-4D1E-B2ED-E73711D573F8}" type="presOf" srcId="{32B1F3CF-08AB-48A3-88FA-9D6711170EDB}" destId="{398BAFD7-08AA-400F-9B60-205203687C35}" srcOrd="0" destOrd="0" presId="urn:microsoft.com/office/officeart/2005/8/layout/process1"/>
    <dgm:cxn modelId="{9B49B329-EA5D-4EE4-BF46-D7DA857F2F41}" type="presOf" srcId="{F0F49110-18F7-499B-BC6F-1AFC4B715C48}" destId="{23CFA9F2-E9AB-479E-8E9D-BFCA975C186E}" srcOrd="0" destOrd="0" presId="urn:microsoft.com/office/officeart/2005/8/layout/process1"/>
    <dgm:cxn modelId="{E8FD2F2B-C0A3-4026-AF8A-BF36D5A34FB8}" type="presOf" srcId="{56E1D483-D3F4-48C9-A32F-AF60AD32CF67}" destId="{9D566990-796D-4483-9401-D242769EAF0C}" srcOrd="0" destOrd="0" presId="urn:microsoft.com/office/officeart/2005/8/layout/process1"/>
    <dgm:cxn modelId="{DF48C12C-7795-4E49-9AA9-FC9096C4439C}" srcId="{FE92A7ED-4704-4940-9F3B-CEB13A669BF0}" destId="{584372B1-730E-4FC3-A818-2E1272442E77}" srcOrd="0" destOrd="0" parTransId="{90867284-606A-4E3D-9DF8-DDE0CB9E147A}" sibTransId="{3113B7D6-B0A5-4D31-B67F-C0EC65E44226}"/>
    <dgm:cxn modelId="{305B395F-8BD5-41BE-8A01-8103AB057A2C}" type="presOf" srcId="{F0EFC7C1-5C7E-4C5F-9446-62A6E356FF8C}" destId="{0A4AFA31-27D5-4E22-80AF-B135813D6558}" srcOrd="0" destOrd="0" presId="urn:microsoft.com/office/officeart/2005/8/layout/process1"/>
    <dgm:cxn modelId="{B0563B61-2DFC-45AC-B2A1-7FFD21B8D6E1}" type="presOf" srcId="{0BFEC525-8ECD-4051-83F6-F1FA3CD659F1}" destId="{C48C0697-70CE-472B-B91F-DB9EB0340D4F}" srcOrd="1" destOrd="0" presId="urn:microsoft.com/office/officeart/2005/8/layout/process1"/>
    <dgm:cxn modelId="{C11EB848-9A76-41C8-B182-D2F4E9E11271}" type="presOf" srcId="{584372B1-730E-4FC3-A818-2E1272442E77}" destId="{B736850D-13E1-44BA-A7FF-5D79482DD661}" srcOrd="0" destOrd="0" presId="urn:microsoft.com/office/officeart/2005/8/layout/process1"/>
    <dgm:cxn modelId="{A6FCD74C-B695-4448-A8A0-CD85E2E4A519}" type="presOf" srcId="{56E1D483-D3F4-48C9-A32F-AF60AD32CF67}" destId="{2E513A93-CE59-48CD-AA98-667103B65872}" srcOrd="1" destOrd="0" presId="urn:microsoft.com/office/officeart/2005/8/layout/process1"/>
    <dgm:cxn modelId="{4690654D-3FBF-4760-9F5D-5ADFACC91157}" type="presOf" srcId="{3113B7D6-B0A5-4D31-B67F-C0EC65E44226}" destId="{8369832C-DB30-4175-975B-3595DA2CA434}" srcOrd="1" destOrd="0" presId="urn:microsoft.com/office/officeart/2005/8/layout/process1"/>
    <dgm:cxn modelId="{772A378D-27CC-4558-9918-BEE2D165A8CF}" type="presOf" srcId="{0BFEC525-8ECD-4051-83F6-F1FA3CD659F1}" destId="{7E5BE933-CA4F-48F4-B0DE-5D6C2675F8A9}" srcOrd="0" destOrd="0" presId="urn:microsoft.com/office/officeart/2005/8/layout/process1"/>
    <dgm:cxn modelId="{F10850A8-FE02-4246-85EC-3A6C296F1744}" srcId="{FE92A7ED-4704-4940-9F3B-CEB13A669BF0}" destId="{F0EFC7C1-5C7E-4C5F-9446-62A6E356FF8C}" srcOrd="2" destOrd="0" parTransId="{8B73CF3B-E4E9-48FE-A5BC-295E89DB2AAC}" sibTransId="{F0F49110-18F7-499B-BC6F-1AFC4B715C48}"/>
    <dgm:cxn modelId="{1F921BB4-382F-45C6-A746-906F36F92F1E}" type="presOf" srcId="{8E97041E-6F73-4F11-AE75-C6725436979C}" destId="{6A429B86-4A60-49DA-AB8D-00BB6EB1C7F0}" srcOrd="0" destOrd="0" presId="urn:microsoft.com/office/officeart/2005/8/layout/process1"/>
    <dgm:cxn modelId="{FA1F68BB-52FC-4E9D-B00D-2D0CC7C4BD90}" srcId="{FE92A7ED-4704-4940-9F3B-CEB13A669BF0}" destId="{32B1F3CF-08AB-48A3-88FA-9D6711170EDB}" srcOrd="3" destOrd="0" parTransId="{8C047A25-F184-42DF-8A97-AE629B19DBC5}" sibTransId="{56E1D483-D3F4-48C9-A32F-AF60AD32CF67}"/>
    <dgm:cxn modelId="{D10B64D3-2DC2-4429-8F3A-A4104F5E0C9D}" type="presOf" srcId="{FE92A7ED-4704-4940-9F3B-CEB13A669BF0}" destId="{3484058D-ADEC-4C4A-B577-617CA1DF13FB}" srcOrd="0" destOrd="0" presId="urn:microsoft.com/office/officeart/2005/8/layout/process1"/>
    <dgm:cxn modelId="{9F1BD8D4-B536-49FB-B596-57B952594767}" type="presOf" srcId="{3113B7D6-B0A5-4D31-B67F-C0EC65E44226}" destId="{8AE4F5E3-D38A-456C-A107-A4366B2EB282}" srcOrd="0" destOrd="0" presId="urn:microsoft.com/office/officeart/2005/8/layout/process1"/>
    <dgm:cxn modelId="{F7FD22E8-FBFE-4138-A974-600ADB62368C}" type="presOf" srcId="{F0F49110-18F7-499B-BC6F-1AFC4B715C48}" destId="{23501E2B-0D45-46D2-A5D7-7D0C779BE4EB}" srcOrd="1" destOrd="0" presId="urn:microsoft.com/office/officeart/2005/8/layout/process1"/>
    <dgm:cxn modelId="{431635E9-84B5-4F7D-AFA6-B43BF29FDA1C}" type="presOf" srcId="{097446BD-7F60-4509-9B77-7159CC084FB0}" destId="{DD7AE674-9303-4A8C-8937-7B1A4860ACFB}" srcOrd="0" destOrd="0" presId="urn:microsoft.com/office/officeart/2005/8/layout/process1"/>
    <dgm:cxn modelId="{F8D5B0EA-A792-4713-BC66-972174853507}" srcId="{FE92A7ED-4704-4940-9F3B-CEB13A669BF0}" destId="{8E97041E-6F73-4F11-AE75-C6725436979C}" srcOrd="4" destOrd="0" parTransId="{BC3B4A1F-FEC3-4BAD-8F56-5C95A7DACEC1}" sibTransId="{3509087D-0553-42A1-B315-12A6E924E210}"/>
    <dgm:cxn modelId="{A14C2F4B-A971-4D12-95AA-D69B304B61CC}" type="presParOf" srcId="{3484058D-ADEC-4C4A-B577-617CA1DF13FB}" destId="{B736850D-13E1-44BA-A7FF-5D79482DD661}" srcOrd="0" destOrd="0" presId="urn:microsoft.com/office/officeart/2005/8/layout/process1"/>
    <dgm:cxn modelId="{BB184CD9-0290-4733-A773-CCBD896D3293}" type="presParOf" srcId="{3484058D-ADEC-4C4A-B577-617CA1DF13FB}" destId="{8AE4F5E3-D38A-456C-A107-A4366B2EB282}" srcOrd="1" destOrd="0" presId="urn:microsoft.com/office/officeart/2005/8/layout/process1"/>
    <dgm:cxn modelId="{CBF0BE49-A598-43A8-9B27-95D5EF88FB8A}" type="presParOf" srcId="{8AE4F5E3-D38A-456C-A107-A4366B2EB282}" destId="{8369832C-DB30-4175-975B-3595DA2CA434}" srcOrd="0" destOrd="0" presId="urn:microsoft.com/office/officeart/2005/8/layout/process1"/>
    <dgm:cxn modelId="{728FD261-4374-4306-9F7E-7BF0BE1BF94E}" type="presParOf" srcId="{3484058D-ADEC-4C4A-B577-617CA1DF13FB}" destId="{DD7AE674-9303-4A8C-8937-7B1A4860ACFB}" srcOrd="2" destOrd="0" presId="urn:microsoft.com/office/officeart/2005/8/layout/process1"/>
    <dgm:cxn modelId="{CA08F22C-D93F-4B48-A75D-E7EB57D68F82}" type="presParOf" srcId="{3484058D-ADEC-4C4A-B577-617CA1DF13FB}" destId="{7E5BE933-CA4F-48F4-B0DE-5D6C2675F8A9}" srcOrd="3" destOrd="0" presId="urn:microsoft.com/office/officeart/2005/8/layout/process1"/>
    <dgm:cxn modelId="{917CDCF1-92ED-4692-9E64-D575990F6BC7}" type="presParOf" srcId="{7E5BE933-CA4F-48F4-B0DE-5D6C2675F8A9}" destId="{C48C0697-70CE-472B-B91F-DB9EB0340D4F}" srcOrd="0" destOrd="0" presId="urn:microsoft.com/office/officeart/2005/8/layout/process1"/>
    <dgm:cxn modelId="{7D9AD2EC-F10B-4930-9673-867A336135E9}" type="presParOf" srcId="{3484058D-ADEC-4C4A-B577-617CA1DF13FB}" destId="{0A4AFA31-27D5-4E22-80AF-B135813D6558}" srcOrd="4" destOrd="0" presId="urn:microsoft.com/office/officeart/2005/8/layout/process1"/>
    <dgm:cxn modelId="{1BC45795-C505-4264-B744-C7D8FAA681A7}" type="presParOf" srcId="{3484058D-ADEC-4C4A-B577-617CA1DF13FB}" destId="{23CFA9F2-E9AB-479E-8E9D-BFCA975C186E}" srcOrd="5" destOrd="0" presId="urn:microsoft.com/office/officeart/2005/8/layout/process1"/>
    <dgm:cxn modelId="{B471107B-C7A5-4FCF-899A-1CBEACE6E84C}" type="presParOf" srcId="{23CFA9F2-E9AB-479E-8E9D-BFCA975C186E}" destId="{23501E2B-0D45-46D2-A5D7-7D0C779BE4EB}" srcOrd="0" destOrd="0" presId="urn:microsoft.com/office/officeart/2005/8/layout/process1"/>
    <dgm:cxn modelId="{076CE549-1471-48FB-AE0B-C25A5C1012CE}" type="presParOf" srcId="{3484058D-ADEC-4C4A-B577-617CA1DF13FB}" destId="{398BAFD7-08AA-400F-9B60-205203687C35}" srcOrd="6" destOrd="0" presId="urn:microsoft.com/office/officeart/2005/8/layout/process1"/>
    <dgm:cxn modelId="{8D5AA5A2-975E-4A78-A0BB-ED6408093AFA}" type="presParOf" srcId="{3484058D-ADEC-4C4A-B577-617CA1DF13FB}" destId="{9D566990-796D-4483-9401-D242769EAF0C}" srcOrd="7" destOrd="0" presId="urn:microsoft.com/office/officeart/2005/8/layout/process1"/>
    <dgm:cxn modelId="{5C4BDC76-AB69-4873-BAA0-6502B69B841E}" type="presParOf" srcId="{9D566990-796D-4483-9401-D242769EAF0C}" destId="{2E513A93-CE59-48CD-AA98-667103B65872}" srcOrd="0" destOrd="0" presId="urn:microsoft.com/office/officeart/2005/8/layout/process1"/>
    <dgm:cxn modelId="{2D54108C-9056-4750-86DF-4ABDD548DCFB}" type="presParOf" srcId="{3484058D-ADEC-4C4A-B577-617CA1DF13FB}" destId="{6A429B86-4A60-49DA-AB8D-00BB6EB1C7F0}" srcOrd="8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736850D-13E1-44BA-A7FF-5D79482DD661}">
      <dsp:nvSpPr>
        <dsp:cNvPr id="0" name=""/>
        <dsp:cNvSpPr/>
      </dsp:nvSpPr>
      <dsp:spPr>
        <a:xfrm>
          <a:off x="7521" y="866706"/>
          <a:ext cx="1493959" cy="1107545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/>
            <a:t>Sample</a:t>
          </a:r>
          <a:br>
            <a:rPr lang="en-US" sz="2000" b="1" kern="1200"/>
          </a:br>
          <a:r>
            <a:rPr lang="en-US" sz="2000" b="1" i="0" kern="1200"/>
            <a:t>Design</a:t>
          </a:r>
          <a:endParaRPr lang="ko-KR" altLang="en-US" sz="2000" b="1" kern="1200">
            <a:effectLst>
              <a:outerShdw blurRad="38100" dist="38100" dir="2700000" algn="tl">
                <a:srgbClr val="000000">
                  <a:alpha val="43137"/>
                </a:srgbClr>
              </a:outerShdw>
            </a:effectLst>
          </a:endParaRPr>
        </a:p>
      </dsp:txBody>
      <dsp:txXfrm>
        <a:off x="39960" y="899145"/>
        <a:ext cx="1429081" cy="1042667"/>
      </dsp:txXfrm>
    </dsp:sp>
    <dsp:sp modelId="{8AE4F5E3-D38A-456C-A107-A4366B2EB282}">
      <dsp:nvSpPr>
        <dsp:cNvPr id="0" name=""/>
        <dsp:cNvSpPr/>
      </dsp:nvSpPr>
      <dsp:spPr>
        <a:xfrm>
          <a:off x="1650877" y="1235228"/>
          <a:ext cx="316719" cy="370502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ko-KR" altLang="en-US" sz="1000" kern="1200"/>
        </a:p>
      </dsp:txBody>
      <dsp:txXfrm>
        <a:off x="1650877" y="1309328"/>
        <a:ext cx="221703" cy="222302"/>
      </dsp:txXfrm>
    </dsp:sp>
    <dsp:sp modelId="{DD7AE674-9303-4A8C-8937-7B1A4860ACFB}">
      <dsp:nvSpPr>
        <dsp:cNvPr id="0" name=""/>
        <dsp:cNvSpPr/>
      </dsp:nvSpPr>
      <dsp:spPr>
        <a:xfrm>
          <a:off x="2099065" y="866706"/>
          <a:ext cx="1754835" cy="1107545"/>
        </a:xfrm>
        <a:prstGeom prst="roundRect">
          <a:avLst>
            <a:gd name="adj" fmla="val 10000"/>
          </a:avLst>
        </a:prstGeom>
        <a:solidFill>
          <a:schemeClr val="accent4">
            <a:hueOff val="2450223"/>
            <a:satOff val="-10194"/>
            <a:lumOff val="2402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 dirty="0"/>
            <a:t>Participant</a:t>
          </a:r>
          <a:br>
            <a:rPr lang="en-US" sz="2000" b="1" kern="1200" dirty="0"/>
          </a:br>
          <a:r>
            <a:rPr lang="en-US" sz="2000" b="1" kern="1200" dirty="0"/>
            <a:t>Recruitment</a:t>
          </a:r>
          <a:endParaRPr lang="ko-KR" altLang="en-US" sz="2000" b="1" kern="1200" dirty="0">
            <a:effectLst/>
          </a:endParaRPr>
        </a:p>
      </dsp:txBody>
      <dsp:txXfrm>
        <a:off x="2131504" y="899145"/>
        <a:ext cx="1689957" cy="1042667"/>
      </dsp:txXfrm>
    </dsp:sp>
    <dsp:sp modelId="{7E5BE933-CA4F-48F4-B0DE-5D6C2675F8A9}">
      <dsp:nvSpPr>
        <dsp:cNvPr id="0" name=""/>
        <dsp:cNvSpPr/>
      </dsp:nvSpPr>
      <dsp:spPr>
        <a:xfrm>
          <a:off x="4003296" y="1235228"/>
          <a:ext cx="316719" cy="370502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hueOff val="3266964"/>
            <a:satOff val="-13592"/>
            <a:lumOff val="3203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ko-KR" altLang="en-US" sz="1000" kern="1200"/>
        </a:p>
      </dsp:txBody>
      <dsp:txXfrm>
        <a:off x="4003296" y="1309328"/>
        <a:ext cx="221703" cy="222302"/>
      </dsp:txXfrm>
    </dsp:sp>
    <dsp:sp modelId="{0A4AFA31-27D5-4E22-80AF-B135813D6558}">
      <dsp:nvSpPr>
        <dsp:cNvPr id="0" name=""/>
        <dsp:cNvSpPr/>
      </dsp:nvSpPr>
      <dsp:spPr>
        <a:xfrm>
          <a:off x="4451484" y="866706"/>
          <a:ext cx="1861563" cy="1107545"/>
        </a:xfrm>
        <a:prstGeom prst="roundRect">
          <a:avLst>
            <a:gd name="adj" fmla="val 10000"/>
          </a:avLst>
        </a:prstGeom>
        <a:solidFill>
          <a:schemeClr val="accent4">
            <a:hueOff val="4900445"/>
            <a:satOff val="-20388"/>
            <a:lumOff val="4804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/>
            <a:t>Biospecimen</a:t>
          </a:r>
          <a:br>
            <a:rPr lang="en-US" sz="2000" kern="1200"/>
          </a:br>
          <a:r>
            <a:rPr lang="en-US" sz="2000" b="1" i="0" kern="1200"/>
            <a:t>Collection</a:t>
          </a:r>
          <a:endParaRPr lang="ko-KR" altLang="en-US" sz="2000" kern="1200"/>
        </a:p>
      </dsp:txBody>
      <dsp:txXfrm>
        <a:off x="4483923" y="899145"/>
        <a:ext cx="1796685" cy="1042667"/>
      </dsp:txXfrm>
    </dsp:sp>
    <dsp:sp modelId="{23CFA9F2-E9AB-479E-8E9D-BFCA975C186E}">
      <dsp:nvSpPr>
        <dsp:cNvPr id="0" name=""/>
        <dsp:cNvSpPr/>
      </dsp:nvSpPr>
      <dsp:spPr>
        <a:xfrm>
          <a:off x="6462443" y="1235228"/>
          <a:ext cx="316719" cy="370502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hueOff val="6533927"/>
            <a:satOff val="-27185"/>
            <a:lumOff val="6405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ko-KR" altLang="en-US" sz="1000" kern="1200"/>
        </a:p>
      </dsp:txBody>
      <dsp:txXfrm>
        <a:off x="6462443" y="1309328"/>
        <a:ext cx="221703" cy="222302"/>
      </dsp:txXfrm>
    </dsp:sp>
    <dsp:sp modelId="{398BAFD7-08AA-400F-9B60-205203687C35}">
      <dsp:nvSpPr>
        <dsp:cNvPr id="0" name=""/>
        <dsp:cNvSpPr/>
      </dsp:nvSpPr>
      <dsp:spPr>
        <a:xfrm>
          <a:off x="6910631" y="866706"/>
          <a:ext cx="1493959" cy="1107545"/>
        </a:xfrm>
        <a:prstGeom prst="roundRect">
          <a:avLst>
            <a:gd name="adj" fmla="val 10000"/>
          </a:avLst>
        </a:prstGeom>
        <a:solidFill>
          <a:schemeClr val="accent4">
            <a:hueOff val="7350668"/>
            <a:satOff val="-30583"/>
            <a:lumOff val="7206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/>
            <a:t>Analysis</a:t>
          </a:r>
          <a:endParaRPr lang="ko-KR" altLang="en-US" sz="2000" kern="1200"/>
        </a:p>
      </dsp:txBody>
      <dsp:txXfrm>
        <a:off x="6943070" y="899145"/>
        <a:ext cx="1429081" cy="1042667"/>
      </dsp:txXfrm>
    </dsp:sp>
    <dsp:sp modelId="{9D566990-796D-4483-9401-D242769EAF0C}">
      <dsp:nvSpPr>
        <dsp:cNvPr id="0" name=""/>
        <dsp:cNvSpPr/>
      </dsp:nvSpPr>
      <dsp:spPr>
        <a:xfrm rot="21576611">
          <a:off x="8545731" y="1228168"/>
          <a:ext cx="299230" cy="370502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hueOff val="9800891"/>
            <a:satOff val="-40777"/>
            <a:lumOff val="9608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ko-KR" altLang="en-US" sz="1000" kern="1200"/>
        </a:p>
      </dsp:txBody>
      <dsp:txXfrm>
        <a:off x="8545732" y="1302573"/>
        <a:ext cx="209461" cy="222302"/>
      </dsp:txXfrm>
    </dsp:sp>
    <dsp:sp modelId="{6A429B86-4A60-49DA-AB8D-00BB6EB1C7F0}">
      <dsp:nvSpPr>
        <dsp:cNvPr id="0" name=""/>
        <dsp:cNvSpPr/>
      </dsp:nvSpPr>
      <dsp:spPr>
        <a:xfrm>
          <a:off x="8969165" y="851876"/>
          <a:ext cx="1736339" cy="1107545"/>
        </a:xfrm>
        <a:prstGeom prst="roundRect">
          <a:avLst>
            <a:gd name="adj" fmla="val 10000"/>
          </a:avLst>
        </a:prstGeom>
        <a:solidFill>
          <a:schemeClr val="accent4">
            <a:hueOff val="9800891"/>
            <a:satOff val="-40777"/>
            <a:lumOff val="9608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/>
            <a:t>Biobanking</a:t>
          </a:r>
          <a:endParaRPr lang="ko-KR" altLang="en-US" sz="2000" kern="1200"/>
        </a:p>
      </dsp:txBody>
      <dsp:txXfrm>
        <a:off x="9001604" y="884315"/>
        <a:ext cx="1671461" cy="1042667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736850D-13E1-44BA-A7FF-5D79482DD661}">
      <dsp:nvSpPr>
        <dsp:cNvPr id="0" name=""/>
        <dsp:cNvSpPr/>
      </dsp:nvSpPr>
      <dsp:spPr>
        <a:xfrm>
          <a:off x="7521" y="866706"/>
          <a:ext cx="1493959" cy="1107545"/>
        </a:xfrm>
        <a:prstGeom prst="roundRect">
          <a:avLst>
            <a:gd name="adj" fmla="val 1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/>
            <a:t>Sample</a:t>
          </a:r>
          <a:br>
            <a:rPr lang="en-US" sz="2000" b="1" kern="1200"/>
          </a:br>
          <a:r>
            <a:rPr lang="en-US" sz="2000" b="1" i="0" kern="1200"/>
            <a:t>Design</a:t>
          </a:r>
          <a:endParaRPr lang="ko-KR" altLang="en-US" sz="2000" b="1" kern="1200">
            <a:effectLst>
              <a:outerShdw blurRad="38100" dist="38100" dir="2700000" algn="tl">
                <a:srgbClr val="000000">
                  <a:alpha val="43137"/>
                </a:srgbClr>
              </a:outerShdw>
            </a:effectLst>
          </a:endParaRPr>
        </a:p>
      </dsp:txBody>
      <dsp:txXfrm>
        <a:off x="39960" y="899145"/>
        <a:ext cx="1429081" cy="1042667"/>
      </dsp:txXfrm>
    </dsp:sp>
    <dsp:sp modelId="{8AE4F5E3-D38A-456C-A107-A4366B2EB282}">
      <dsp:nvSpPr>
        <dsp:cNvPr id="0" name=""/>
        <dsp:cNvSpPr/>
      </dsp:nvSpPr>
      <dsp:spPr>
        <a:xfrm>
          <a:off x="1650877" y="1235228"/>
          <a:ext cx="316719" cy="370502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ko-KR" altLang="en-US" sz="1000" kern="1200"/>
        </a:p>
      </dsp:txBody>
      <dsp:txXfrm>
        <a:off x="1650877" y="1309328"/>
        <a:ext cx="221703" cy="222302"/>
      </dsp:txXfrm>
    </dsp:sp>
    <dsp:sp modelId="{DD7AE674-9303-4A8C-8937-7B1A4860ACFB}">
      <dsp:nvSpPr>
        <dsp:cNvPr id="0" name=""/>
        <dsp:cNvSpPr/>
      </dsp:nvSpPr>
      <dsp:spPr>
        <a:xfrm>
          <a:off x="2099065" y="866706"/>
          <a:ext cx="1754835" cy="1107545"/>
        </a:xfrm>
        <a:prstGeom prst="roundRect">
          <a:avLst>
            <a:gd name="adj" fmla="val 10000"/>
          </a:avLst>
        </a:prstGeom>
        <a:solidFill>
          <a:schemeClr val="accent4">
            <a:hueOff val="2450223"/>
            <a:satOff val="-10194"/>
            <a:lumOff val="2402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 dirty="0"/>
            <a:t>Participant</a:t>
          </a:r>
          <a:br>
            <a:rPr lang="en-US" sz="2000" b="1" kern="1200" dirty="0"/>
          </a:br>
          <a:r>
            <a:rPr lang="en-US" sz="2000" b="1" kern="1200" dirty="0"/>
            <a:t>Recruitment</a:t>
          </a:r>
          <a:endParaRPr lang="ko-KR" altLang="en-US" sz="2000" b="1" kern="1200" dirty="0">
            <a:effectLst/>
          </a:endParaRPr>
        </a:p>
      </dsp:txBody>
      <dsp:txXfrm>
        <a:off x="2131504" y="899145"/>
        <a:ext cx="1689957" cy="1042667"/>
      </dsp:txXfrm>
    </dsp:sp>
    <dsp:sp modelId="{7E5BE933-CA4F-48F4-B0DE-5D6C2675F8A9}">
      <dsp:nvSpPr>
        <dsp:cNvPr id="0" name=""/>
        <dsp:cNvSpPr/>
      </dsp:nvSpPr>
      <dsp:spPr>
        <a:xfrm>
          <a:off x="4003296" y="1235228"/>
          <a:ext cx="316719" cy="370502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hueOff val="3266964"/>
            <a:satOff val="-13592"/>
            <a:lumOff val="3203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ko-KR" altLang="en-US" sz="1000" kern="1200"/>
        </a:p>
      </dsp:txBody>
      <dsp:txXfrm>
        <a:off x="4003296" y="1309328"/>
        <a:ext cx="221703" cy="222302"/>
      </dsp:txXfrm>
    </dsp:sp>
    <dsp:sp modelId="{0A4AFA31-27D5-4E22-80AF-B135813D6558}">
      <dsp:nvSpPr>
        <dsp:cNvPr id="0" name=""/>
        <dsp:cNvSpPr/>
      </dsp:nvSpPr>
      <dsp:spPr>
        <a:xfrm>
          <a:off x="4451484" y="866706"/>
          <a:ext cx="1861563" cy="1107545"/>
        </a:xfrm>
        <a:prstGeom prst="roundRect">
          <a:avLst>
            <a:gd name="adj" fmla="val 10000"/>
          </a:avLst>
        </a:prstGeom>
        <a:solidFill>
          <a:schemeClr val="accent4">
            <a:hueOff val="4900445"/>
            <a:satOff val="-20388"/>
            <a:lumOff val="4804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/>
            <a:t>Biospecimen</a:t>
          </a:r>
          <a:br>
            <a:rPr lang="en-US" sz="2000" kern="1200"/>
          </a:br>
          <a:r>
            <a:rPr lang="en-US" sz="2000" b="1" i="0" kern="1200"/>
            <a:t>Collection</a:t>
          </a:r>
          <a:endParaRPr lang="ko-KR" altLang="en-US" sz="2000" kern="1200"/>
        </a:p>
      </dsp:txBody>
      <dsp:txXfrm>
        <a:off x="4483923" y="899145"/>
        <a:ext cx="1796685" cy="1042667"/>
      </dsp:txXfrm>
    </dsp:sp>
    <dsp:sp modelId="{23CFA9F2-E9AB-479E-8E9D-BFCA975C186E}">
      <dsp:nvSpPr>
        <dsp:cNvPr id="0" name=""/>
        <dsp:cNvSpPr/>
      </dsp:nvSpPr>
      <dsp:spPr>
        <a:xfrm>
          <a:off x="6462443" y="1235228"/>
          <a:ext cx="316719" cy="370502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hueOff val="6533927"/>
            <a:satOff val="-27185"/>
            <a:lumOff val="6405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ko-KR" altLang="en-US" sz="1000" kern="1200"/>
        </a:p>
      </dsp:txBody>
      <dsp:txXfrm>
        <a:off x="6462443" y="1309328"/>
        <a:ext cx="221703" cy="222302"/>
      </dsp:txXfrm>
    </dsp:sp>
    <dsp:sp modelId="{398BAFD7-08AA-400F-9B60-205203687C35}">
      <dsp:nvSpPr>
        <dsp:cNvPr id="0" name=""/>
        <dsp:cNvSpPr/>
      </dsp:nvSpPr>
      <dsp:spPr>
        <a:xfrm>
          <a:off x="6910631" y="866706"/>
          <a:ext cx="1493959" cy="1107545"/>
        </a:xfrm>
        <a:prstGeom prst="roundRect">
          <a:avLst>
            <a:gd name="adj" fmla="val 10000"/>
          </a:avLst>
        </a:prstGeom>
        <a:solidFill>
          <a:schemeClr val="accent4">
            <a:hueOff val="7350668"/>
            <a:satOff val="-30583"/>
            <a:lumOff val="7206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/>
            <a:t>Analysis</a:t>
          </a:r>
          <a:endParaRPr lang="ko-KR" altLang="en-US" sz="2000" kern="1200"/>
        </a:p>
      </dsp:txBody>
      <dsp:txXfrm>
        <a:off x="6943070" y="899145"/>
        <a:ext cx="1429081" cy="1042667"/>
      </dsp:txXfrm>
    </dsp:sp>
    <dsp:sp modelId="{9D566990-796D-4483-9401-D242769EAF0C}">
      <dsp:nvSpPr>
        <dsp:cNvPr id="0" name=""/>
        <dsp:cNvSpPr/>
      </dsp:nvSpPr>
      <dsp:spPr>
        <a:xfrm rot="21576611">
          <a:off x="8545731" y="1228168"/>
          <a:ext cx="299230" cy="370502"/>
        </a:xfrm>
        <a:prstGeom prst="rightArrow">
          <a:avLst>
            <a:gd name="adj1" fmla="val 60000"/>
            <a:gd name="adj2" fmla="val 50000"/>
          </a:avLst>
        </a:prstGeom>
        <a:solidFill>
          <a:schemeClr val="accent4">
            <a:hueOff val="9800891"/>
            <a:satOff val="-40777"/>
            <a:lumOff val="9608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44500" latinLnBrk="1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ko-KR" altLang="en-US" sz="1000" kern="1200"/>
        </a:p>
      </dsp:txBody>
      <dsp:txXfrm>
        <a:off x="8545732" y="1302573"/>
        <a:ext cx="209461" cy="222302"/>
      </dsp:txXfrm>
    </dsp:sp>
    <dsp:sp modelId="{6A429B86-4A60-49DA-AB8D-00BB6EB1C7F0}">
      <dsp:nvSpPr>
        <dsp:cNvPr id="0" name=""/>
        <dsp:cNvSpPr/>
      </dsp:nvSpPr>
      <dsp:spPr>
        <a:xfrm>
          <a:off x="8969165" y="851876"/>
          <a:ext cx="1736339" cy="1107545"/>
        </a:xfrm>
        <a:prstGeom prst="roundRect">
          <a:avLst>
            <a:gd name="adj" fmla="val 10000"/>
          </a:avLst>
        </a:prstGeom>
        <a:solidFill>
          <a:schemeClr val="accent4">
            <a:hueOff val="9800891"/>
            <a:satOff val="-40777"/>
            <a:lumOff val="9608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 latinLnBrk="1">
            <a:lnSpc>
              <a:spcPct val="10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b="1" i="0" kern="1200"/>
            <a:t>Biobanking</a:t>
          </a:r>
          <a:endParaRPr lang="ko-KR" altLang="en-US" sz="2000" kern="1200"/>
        </a:p>
      </dsp:txBody>
      <dsp:txXfrm>
        <a:off x="9001604" y="884315"/>
        <a:ext cx="1671461" cy="104266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346672E-4E7F-47CB-822B-3E4D6A77F5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D8AB929-278D-47BB-96CB-75AE2F2962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AE64028-4E10-41DA-82A1-2C2BE2A3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A1B269E-0973-47B5-B331-6668D28668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029F6F7-6179-4CB1-803C-0F75A6074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3771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308BCA2-F6B8-4835-922A-6FA0DF1B4A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04A3C53-DBF0-46E3-8FB1-D41916BE9A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B12555F-1935-4605-9528-AD2FD25FD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16E814B-5CD3-4CA4-94A9-5180B6D9D8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14CCAB2-70D1-4B90-BA30-5C3BE0CDAD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4269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1E311C9F-0A52-4899-9619-AB04886A6A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CF24BA9-5945-4893-B8F8-D2417B3F2A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D9ADE67-7A64-42AD-9A85-D297569AD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7235240-3F5C-47E3-9E73-1C408DF616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3725FB9-1741-4B00-8439-7909EAE2BF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79941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04DB424-4A0C-483C-800D-A063F32E91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526E748-923C-4AC1-A971-DAFFC02DB9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DD6A204-D269-462B-8BE4-B74C9ED77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6E041A2-D561-4901-A610-EDEF89D1DC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7501BB9-E07D-488E-A859-A8411F3A8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1338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593F929-7FD6-4F3C-9CC8-913C022DB3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9E7D059D-4196-4058-AEE5-F30CC64410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FCAEA79-F281-45F5-B82E-49D79ED23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E7CB1D4-3F4A-43DB-85DD-11495608C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1A08C70-2B84-400D-81B9-704AEDDE9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562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AF5B422-DCFD-4E24-B2A9-8B2251A30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B48C219-0A92-4D3B-AD0E-26485251E0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CD8B194-1C59-41C7-925B-DF57EB6D0B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D0BE151-AF37-48D1-90FC-8BC387872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D61C758-A2AB-42A6-9A06-DFB2F67D1C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A0B50AD-D463-4FE6-B89F-E909A12398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70153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24F5BEE-314A-4339-A019-50828A00B1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EB4E143-4F75-4F72-860F-5BE34134C4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039619E-CB55-4E34-BCF3-FA999A9083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DA5197D-B81C-494A-B2A2-5CBF78AAA0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ADB650B1-5A1B-4B4C-A831-B6DB4C1C85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2860A084-533D-4F62-804B-A2F497873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6232925F-B3F4-4CEA-ADED-20C75F29A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CBA43086-E6B0-406E-8FFE-F6C7F6755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45516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60722DC-DB6D-4A31-9227-766FEC5E74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352D5922-08FA-4439-A7D9-26308D2C6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5EF9FEE0-8B2A-46BD-9738-AF2894422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28843E7E-F45D-48E5-AAC1-67C5C454FE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071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7DCBE7C2-045C-45A8-ACA3-DFA255BFA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6E62F27-3926-40B3-AAF3-6F2AA0568A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376B340-F9CF-477D-BEA8-000C2A7BE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8440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E8B7671-BCC4-49B8-964D-C5782CEE0C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FC4D2DC-AA8E-4B74-B143-EEAA7F32A8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528F10D-AEB5-4626-85C6-930A15D86E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9512016-0F4A-4261-B0E1-CFE34D7CC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ACC5D09-DB47-456D-99BA-09445E877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18B2374-861B-4F52-B5E2-CA3B18AE4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487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9576CF1-05D9-4A4B-9D9E-E6D54EC57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A938F4C6-A9E8-45E7-8A6D-8977047F0A1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983C49A-ED02-4AC1-8621-74B48F0B21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D7D72EB-8E87-4421-881B-0B8007730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7585255-832B-4169-8815-BB196DBE5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FB8EF35-6004-413D-94C2-87B42B64F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9106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0A7C8D91-2EB8-4F71-9FF1-F4CFD5D053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D163D1F-D1BD-4EF3-91BA-A6AEC9A422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571CF00-26E7-48FE-BB19-A70B67F13B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2C1E4-2A59-46E9-A7BC-0C12E0392E60}" type="datetimeFigureOut">
              <a:rPr lang="ko-KR" altLang="en-US" smtClean="0"/>
              <a:t>2025-12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B6C2738-A9C1-4413-9DF5-79CCC1E501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7868025-DC4D-42C4-BD43-2CFD9917CC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A44E71-BE78-488B-8CD4-2447A008AF8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09633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2.xml"/><Relationship Id="rId3" Type="http://schemas.openxmlformats.org/officeDocument/2006/relationships/diagramLayout" Target="../diagrams/layout1.xml"/><Relationship Id="rId7" Type="http://schemas.openxmlformats.org/officeDocument/2006/relationships/diagramData" Target="../diagrams/data2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11" Type="http://schemas.microsoft.com/office/2007/relationships/diagramDrawing" Target="../diagrams/drawing2.xml"/><Relationship Id="rId5" Type="http://schemas.openxmlformats.org/officeDocument/2006/relationships/diagramColors" Target="../diagrams/colors1.xml"/><Relationship Id="rId10" Type="http://schemas.openxmlformats.org/officeDocument/2006/relationships/diagramColors" Target="../diagrams/colors2.xml"/><Relationship Id="rId4" Type="http://schemas.openxmlformats.org/officeDocument/2006/relationships/diagramQuickStyle" Target="../diagrams/quickStyle1.xml"/><Relationship Id="rId9" Type="http://schemas.openxmlformats.org/officeDocument/2006/relationships/diagramQuickStyle" Target="../diagrams/quickStyl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내용 개체 틀 4">
            <a:extLst>
              <a:ext uri="{FF2B5EF4-FFF2-40B4-BE49-F238E27FC236}">
                <a16:creationId xmlns:a16="http://schemas.microsoft.com/office/drawing/2014/main" id="{0E23406E-325F-4176-BBC5-569C320C818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786476188"/>
              </p:ext>
            </p:extLst>
          </p:nvPr>
        </p:nvGraphicFramePr>
        <p:xfrm>
          <a:off x="738206" y="245142"/>
          <a:ext cx="10746037" cy="284095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pSp>
        <p:nvGrpSpPr>
          <p:cNvPr id="2" name="그룹 1">
            <a:extLst>
              <a:ext uri="{FF2B5EF4-FFF2-40B4-BE49-F238E27FC236}">
                <a16:creationId xmlns:a16="http://schemas.microsoft.com/office/drawing/2014/main" id="{8312A942-F1DC-4A83-A981-FE981096D72F}"/>
              </a:ext>
            </a:extLst>
          </p:cNvPr>
          <p:cNvGrpSpPr/>
          <p:nvPr/>
        </p:nvGrpSpPr>
        <p:grpSpPr>
          <a:xfrm>
            <a:off x="756140" y="1895034"/>
            <a:ext cx="10691445" cy="2624212"/>
            <a:chOff x="756140" y="1895034"/>
            <a:chExt cx="10691445" cy="2624212"/>
          </a:xfrm>
        </p:grpSpPr>
        <p:grpSp>
          <p:nvGrpSpPr>
            <p:cNvPr id="17" name="그룹 16">
              <a:extLst>
                <a:ext uri="{FF2B5EF4-FFF2-40B4-BE49-F238E27FC236}">
                  <a16:creationId xmlns:a16="http://schemas.microsoft.com/office/drawing/2014/main" id="{6E74A058-FF9C-40EA-A28E-0A3D7B8DBAFD}"/>
                </a:ext>
              </a:extLst>
            </p:cNvPr>
            <p:cNvGrpSpPr/>
            <p:nvPr/>
          </p:nvGrpSpPr>
          <p:grpSpPr>
            <a:xfrm>
              <a:off x="756140" y="2405083"/>
              <a:ext cx="1494692" cy="2114163"/>
              <a:chOff x="257472" y="2630575"/>
              <a:chExt cx="1024453" cy="864000"/>
            </a:xfrm>
          </p:grpSpPr>
          <p:sp>
            <p:nvSpPr>
              <p:cNvPr id="18" name="사각형: 둥근 모서리 17">
                <a:extLst>
                  <a:ext uri="{FF2B5EF4-FFF2-40B4-BE49-F238E27FC236}">
                    <a16:creationId xmlns:a16="http://schemas.microsoft.com/office/drawing/2014/main" id="{F46E1ADD-020F-486D-A27D-13A6D3B89435}"/>
                  </a:ext>
                </a:extLst>
              </p:cNvPr>
              <p:cNvSpPr/>
              <p:nvPr/>
            </p:nvSpPr>
            <p:spPr>
              <a:xfrm>
                <a:off x="257472" y="2630575"/>
                <a:ext cx="1024453" cy="864000"/>
              </a:xfrm>
              <a:prstGeom prst="roundRect">
                <a:avLst>
                  <a:gd name="adj" fmla="val 10000"/>
                </a:avLst>
              </a:prstGeom>
            </p:spPr>
            <p:style>
              <a:lnRef idx="2">
                <a:schemeClr val="accent4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lt1">
                  <a:alpha val="9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9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9" name="사각형: 둥근 모서리 4">
                <a:extLst>
                  <a:ext uri="{FF2B5EF4-FFF2-40B4-BE49-F238E27FC236}">
                    <a16:creationId xmlns:a16="http://schemas.microsoft.com/office/drawing/2014/main" id="{A694E038-D936-464B-BEE8-5A239AC4602A}"/>
                  </a:ext>
                </a:extLst>
              </p:cNvPr>
              <p:cNvSpPr txBox="1"/>
              <p:nvPr/>
            </p:nvSpPr>
            <p:spPr>
              <a:xfrm>
                <a:off x="282778" y="2655881"/>
                <a:ext cx="973841" cy="813388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106680" tIns="106680" rIns="106680" bIns="106680" numCol="1" spcCol="1270" anchor="t" anchorCtr="0">
                <a:noAutofit/>
              </a:bodyPr>
              <a:lstStyle/>
              <a:p>
                <a:pPr marL="114300" lvl="1" indent="-114300" algn="l" defTabSz="666750" latinLnBrk="1">
                  <a:lnSpc>
                    <a:spcPct val="90000"/>
                  </a:lnSpc>
                  <a:spcBef>
                    <a:spcPct val="0"/>
                  </a:spcBef>
                  <a:spcAft>
                    <a:spcPct val="15000"/>
                  </a:spcAft>
                  <a:buChar char="•"/>
                </a:pPr>
                <a:endParaRPr lang="ko-KR" altLang="en-US" sz="1500" kern="1200"/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C2EC3AE-9A58-41F8-82A2-2CBC94FA379E}"/>
                </a:ext>
              </a:extLst>
            </p:cNvPr>
            <p:cNvSpPr txBox="1"/>
            <p:nvPr/>
          </p:nvSpPr>
          <p:spPr>
            <a:xfrm>
              <a:off x="861946" y="2419792"/>
              <a:ext cx="1507210" cy="203132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400" b="1" i="0">
                  <a:solidFill>
                    <a:srgbClr val="333333"/>
                  </a:solidFill>
                  <a:effectLst/>
                  <a:latin typeface="+mn-ea"/>
                </a:rPr>
                <a:t>Complex Stratified Sampling</a:t>
              </a:r>
            </a:p>
            <a:p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• Korean  </a:t>
              </a:r>
            </a:p>
            <a:p>
              <a:r>
                <a:rPr lang="en-US" altLang="ko-KR" sz="1200">
                  <a:solidFill>
                    <a:srgbClr val="666666"/>
                  </a:solidFill>
                  <a:latin typeface="+mn-ea"/>
                </a:rPr>
                <a:t>  </a:t>
              </a:r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residents aged </a:t>
              </a:r>
            </a:p>
            <a:p>
              <a:r>
                <a:rPr lang="en-US" altLang="ko-KR" sz="1200">
                  <a:solidFill>
                    <a:srgbClr val="666666"/>
                  </a:solidFill>
                  <a:latin typeface="+mn-ea"/>
                </a:rPr>
                <a:t>  </a:t>
              </a:r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3-79 years</a:t>
              </a:r>
            </a:p>
            <a:p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• Survey period: </a:t>
              </a:r>
            </a:p>
            <a:p>
              <a:r>
                <a:rPr lang="en-US" altLang="ko-KR" sz="1200">
                  <a:solidFill>
                    <a:srgbClr val="666666"/>
                  </a:solidFill>
                  <a:latin typeface="+mn-ea"/>
                </a:rPr>
                <a:t>  </a:t>
              </a:r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3-year cycle</a:t>
              </a:r>
              <a:br>
                <a:rPr lang="en-US" altLang="ko-KR" sz="1200">
                  <a:latin typeface="+mn-ea"/>
                </a:rPr>
              </a:br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• 5,000 </a:t>
              </a:r>
            </a:p>
            <a:p>
              <a:r>
                <a:rPr lang="en-US" altLang="ko-KR" sz="1200">
                  <a:solidFill>
                    <a:srgbClr val="666666"/>
                  </a:solidFill>
                  <a:latin typeface="+mn-ea"/>
                </a:rPr>
                <a:t>  </a:t>
              </a:r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participants</a:t>
              </a:r>
              <a:endParaRPr lang="ko-KR" altLang="en-US" sz="1400">
                <a:latin typeface="+mn-ea"/>
              </a:endParaRPr>
            </a:p>
          </p:txBody>
        </p:sp>
        <p:grpSp>
          <p:nvGrpSpPr>
            <p:cNvPr id="22" name="그룹 21">
              <a:extLst>
                <a:ext uri="{FF2B5EF4-FFF2-40B4-BE49-F238E27FC236}">
                  <a16:creationId xmlns:a16="http://schemas.microsoft.com/office/drawing/2014/main" id="{C58C1D93-F41D-4EE5-8232-D9716E64DEC0}"/>
                </a:ext>
              </a:extLst>
            </p:cNvPr>
            <p:cNvGrpSpPr/>
            <p:nvPr/>
          </p:nvGrpSpPr>
          <p:grpSpPr>
            <a:xfrm>
              <a:off x="2858157" y="2423254"/>
              <a:ext cx="1802652" cy="2069612"/>
              <a:chOff x="2011396" y="2599115"/>
              <a:chExt cx="1061207" cy="864000"/>
            </a:xfrm>
          </p:grpSpPr>
          <p:sp>
            <p:nvSpPr>
              <p:cNvPr id="23" name="사각형: 둥근 모서리 22">
                <a:extLst>
                  <a:ext uri="{FF2B5EF4-FFF2-40B4-BE49-F238E27FC236}">
                    <a16:creationId xmlns:a16="http://schemas.microsoft.com/office/drawing/2014/main" id="{CB19A5E8-8778-45B3-9947-1B57ABA44652}"/>
                  </a:ext>
                </a:extLst>
              </p:cNvPr>
              <p:cNvSpPr/>
              <p:nvPr/>
            </p:nvSpPr>
            <p:spPr>
              <a:xfrm>
                <a:off x="2011396" y="2599115"/>
                <a:ext cx="1024453" cy="864000"/>
              </a:xfrm>
              <a:prstGeom prst="roundRect">
                <a:avLst>
                  <a:gd name="adj" fmla="val 10000"/>
                </a:avLst>
              </a:prstGeom>
            </p:spPr>
            <p:style>
              <a:lnRef idx="2">
                <a:schemeClr val="accent4">
                  <a:hueOff val="2450223"/>
                  <a:satOff val="-10194"/>
                  <a:lumOff val="2402"/>
                  <a:alphaOff val="0"/>
                </a:schemeClr>
              </a:lnRef>
              <a:fillRef idx="1">
                <a:schemeClr val="lt1">
                  <a:alpha val="9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9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24" name="사각형: 둥근 모서리 4">
                <a:extLst>
                  <a:ext uri="{FF2B5EF4-FFF2-40B4-BE49-F238E27FC236}">
                    <a16:creationId xmlns:a16="http://schemas.microsoft.com/office/drawing/2014/main" id="{D38197A8-7D14-40CC-BBAD-40FA119DDBAF}"/>
                  </a:ext>
                </a:extLst>
              </p:cNvPr>
              <p:cNvSpPr txBox="1"/>
              <p:nvPr/>
            </p:nvSpPr>
            <p:spPr>
              <a:xfrm>
                <a:off x="2098762" y="2606639"/>
                <a:ext cx="973841" cy="813388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106680" tIns="106680" rIns="106680" bIns="106680" numCol="1" spcCol="1270" anchor="t" anchorCtr="0">
                <a:noAutofit/>
              </a:bodyPr>
              <a:lstStyle/>
              <a:p>
                <a:pPr marL="0" lvl="1" algn="l" defTabSz="666750" latinLnBrk="1">
                  <a:lnSpc>
                    <a:spcPct val="90000"/>
                  </a:lnSpc>
                  <a:spcBef>
                    <a:spcPct val="0"/>
                  </a:spcBef>
                  <a:spcAft>
                    <a:spcPct val="15000"/>
                  </a:spcAft>
                </a:pPr>
                <a:r>
                  <a:rPr lang="en-US" altLang="ko-KR" sz="1400" b="1">
                    <a:latin typeface="+mn-ea"/>
                  </a:rPr>
                  <a:t>Selection of survey households</a:t>
                </a:r>
              </a:p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ko-KR" sz="1200" b="0" i="0">
                    <a:solidFill>
                      <a:schemeClr val="tx1"/>
                    </a:solidFill>
                    <a:effectLst/>
                    <a:latin typeface="+mn-ea"/>
                  </a:rPr>
                  <a:t>• IRB approval</a:t>
                </a:r>
                <a:br>
                  <a:rPr lang="en-US" altLang="ko-KR" sz="1200">
                    <a:solidFill>
                      <a:schemeClr val="tx1"/>
                    </a:solidFill>
                    <a:latin typeface="+mn-ea"/>
                  </a:rPr>
                </a:br>
                <a:r>
                  <a:rPr lang="en-US" altLang="ko-KR" sz="1200" b="0" i="0">
                    <a:solidFill>
                      <a:schemeClr val="tx1"/>
                    </a:solidFill>
                    <a:effectLst/>
                    <a:latin typeface="+mn-ea"/>
                  </a:rPr>
                  <a:t>• Written informed </a:t>
                </a:r>
              </a:p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ko-KR" sz="1200">
                    <a:solidFill>
                      <a:schemeClr val="tx1"/>
                    </a:solidFill>
                    <a:latin typeface="+mn-ea"/>
                  </a:rPr>
                  <a:t>  </a:t>
                </a:r>
                <a:r>
                  <a:rPr lang="en-US" altLang="ko-KR" sz="1200" b="0" i="0">
                    <a:solidFill>
                      <a:schemeClr val="tx1"/>
                    </a:solidFill>
                    <a:effectLst/>
                    <a:latin typeface="+mn-ea"/>
                  </a:rPr>
                  <a:t>consent</a:t>
                </a:r>
              </a:p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ko-KR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666666"/>
                    </a:solidFill>
                    <a:effectLst/>
                    <a:uLnTx/>
                    <a:uFillTx/>
                    <a:latin typeface="맑은 고딕" panose="020B0503020000020004" pitchFamily="50" charset="-127"/>
                    <a:ea typeface="맑은 고딕" panose="020B0503020000020004" pitchFamily="50" charset="-127"/>
                    <a:cs typeface="+mn-cs"/>
                  </a:rPr>
                  <a:t>• </a:t>
                </a:r>
                <a:r>
                  <a:rPr lang="en-US" altLang="ko-KR" sz="1200"/>
                  <a:t>Provision of</a:t>
                </a:r>
              </a:p>
              <a:p>
                <a:pPr marL="0" marR="0" lvl="0" indent="0" algn="l" defTabSz="914400" rtl="0" eaLnBrk="1" fontAlgn="auto" latinLnBrk="1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altLang="ko-KR" sz="1200"/>
                  <a:t>  incentives</a:t>
                </a:r>
              </a:p>
            </p:txBody>
          </p:sp>
        </p:grpSp>
        <p:sp>
          <p:nvSpPr>
            <p:cNvPr id="25" name="사각형: 둥근 모서리 24">
              <a:extLst>
                <a:ext uri="{FF2B5EF4-FFF2-40B4-BE49-F238E27FC236}">
                  <a16:creationId xmlns:a16="http://schemas.microsoft.com/office/drawing/2014/main" id="{E8F456AC-522D-4E82-A1FB-0386FA9A79DA}"/>
                </a:ext>
              </a:extLst>
            </p:cNvPr>
            <p:cNvSpPr/>
            <p:nvPr/>
          </p:nvSpPr>
          <p:spPr>
            <a:xfrm>
              <a:off x="5232081" y="2443085"/>
              <a:ext cx="1757804" cy="2040993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accent4">
                <a:hueOff val="4900445"/>
                <a:satOff val="-20388"/>
                <a:lumOff val="4804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r>
                <a:rPr lang="en-US" altLang="ko-KR" sz="1400" b="1"/>
                <a:t>Five regional hub institutions nationwide</a:t>
              </a: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ea"/>
                  <a:cs typeface="+mn-cs"/>
                </a:rPr>
                <a:t>• </a:t>
              </a:r>
              <a:r>
                <a:rPr lang="en-US" altLang="ko-KR" sz="1200" b="0" i="0">
                  <a:solidFill>
                    <a:schemeClr val="tx1"/>
                  </a:solidFill>
                  <a:effectLst/>
                  <a:latin typeface="+mn-ea"/>
                </a:rPr>
                <a:t>Anthropometry, </a:t>
              </a:r>
              <a:endParaRPr kumimoji="0" lang="en-US" altLang="ko-KR" sz="120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ea"/>
                <a:cs typeface="+mn-cs"/>
              </a:endParaRP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ea"/>
                  <a:cs typeface="+mn-cs"/>
                </a:rPr>
                <a:t>• </a:t>
              </a:r>
              <a:r>
                <a:rPr lang="en-US" altLang="ko-KR" sz="1200">
                  <a:solidFill>
                    <a:schemeClr val="tx1"/>
                  </a:solidFill>
                  <a:latin typeface="+mn-ea"/>
                </a:rPr>
                <a:t>Blood and   </a:t>
              </a: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200">
                  <a:solidFill>
                    <a:schemeClr val="tx1"/>
                  </a:solidFill>
                  <a:latin typeface="+mn-ea"/>
                </a:rPr>
                <a:t>  urine collection</a:t>
              </a: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ea"/>
                  <a:cs typeface="+mn-cs"/>
                </a:rPr>
                <a:t>• </a:t>
              </a:r>
              <a:r>
                <a:rPr lang="en-US" altLang="ko-KR" sz="1200">
                  <a:solidFill>
                    <a:schemeClr val="tx1"/>
                  </a:solidFill>
                  <a:effectLst/>
                  <a:latin typeface="+mn-ea"/>
                  <a:cs typeface="Times New Roman" panose="02020603050405020304" pitchFamily="18" charset="0"/>
                </a:rPr>
                <a:t>Questionnaire</a:t>
              </a: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ea"/>
                  <a:cs typeface="+mn-cs"/>
                </a:rPr>
                <a:t>• Dietary </a:t>
              </a: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200">
                  <a:solidFill>
                    <a:schemeClr val="tx1"/>
                  </a:solidFill>
                  <a:latin typeface="+mn-ea"/>
                </a:rPr>
                <a:t>  assessment</a:t>
              </a:r>
              <a:endParaRPr kumimoji="0" lang="ko-KR" altLang="en-US" sz="18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ea"/>
                <a:cs typeface="+mn-cs"/>
              </a:endParaRPr>
            </a:p>
          </p:txBody>
        </p:sp>
        <p:sp>
          <p:nvSpPr>
            <p:cNvPr id="26" name="사각형: 둥근 모서리 25">
              <a:extLst>
                <a:ext uri="{FF2B5EF4-FFF2-40B4-BE49-F238E27FC236}">
                  <a16:creationId xmlns:a16="http://schemas.microsoft.com/office/drawing/2014/main" id="{FE401954-9E3A-4215-972D-2607699DBAED}"/>
                </a:ext>
              </a:extLst>
            </p:cNvPr>
            <p:cNvSpPr/>
            <p:nvPr/>
          </p:nvSpPr>
          <p:spPr>
            <a:xfrm>
              <a:off x="7685133" y="2434293"/>
              <a:ext cx="1520413" cy="2067369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accent4">
                <a:hueOff val="7350668"/>
                <a:satOff val="-30583"/>
                <a:lumOff val="7206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r>
                <a:rPr lang="en-US" altLang="ko-KR" sz="1400" b="1"/>
                <a:t>Hazardous substance analysis</a:t>
              </a: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+mn-ea"/>
                  <a:cs typeface="+mn-cs"/>
                </a:rPr>
                <a:t>• </a:t>
              </a:r>
              <a:r>
                <a:rPr lang="en-US" altLang="ko-KR" sz="1200" b="0" i="0">
                  <a:solidFill>
                    <a:schemeClr val="tx1"/>
                  </a:solidFill>
                  <a:effectLst/>
                  <a:latin typeface="+mn-ea"/>
                </a:rPr>
                <a:t>(Legacy) PFAS </a:t>
              </a:r>
              <a:br>
                <a:rPr lang="en-US" altLang="ko-KR" sz="1200">
                  <a:solidFill>
                    <a:schemeClr val="tx1"/>
                  </a:solidFill>
                  <a:latin typeface="+mn-ea"/>
                </a:rPr>
              </a:br>
              <a:r>
                <a:rPr lang="en-US" altLang="ko-KR" sz="1200" b="0" i="0">
                  <a:solidFill>
                    <a:schemeClr val="tx1"/>
                  </a:solidFill>
                  <a:effectLst/>
                  <a:latin typeface="+mn-ea"/>
                </a:rPr>
                <a:t>• (Alternative) </a:t>
              </a: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ko-KR" sz="1200">
                  <a:solidFill>
                    <a:schemeClr val="tx1"/>
                  </a:solidFill>
                  <a:latin typeface="+mn-ea"/>
                </a:rPr>
                <a:t>  </a:t>
              </a:r>
              <a:r>
                <a:rPr lang="en-US" altLang="ko-KR" sz="1200" b="0" i="0">
                  <a:solidFill>
                    <a:schemeClr val="tx1"/>
                  </a:solidFill>
                  <a:effectLst/>
                  <a:latin typeface="+mn-ea"/>
                </a:rPr>
                <a:t>Phthalates</a:t>
              </a:r>
              <a:br>
                <a:rPr lang="en-US" altLang="ko-KR" sz="1200">
                  <a:solidFill>
                    <a:schemeClr val="tx1"/>
                  </a:solidFill>
                  <a:latin typeface="+mn-ea"/>
                </a:rPr>
              </a:br>
              <a:r>
                <a:rPr lang="en-US" altLang="ko-KR" sz="1200" b="0" i="0">
                  <a:solidFill>
                    <a:schemeClr val="tx1"/>
                  </a:solidFill>
                  <a:effectLst/>
                  <a:latin typeface="+mn-ea"/>
                </a:rPr>
                <a:t>• Heavy metals</a:t>
              </a:r>
              <a:r>
                <a:rPr kumimoji="0" lang="en-US" altLang="ko-KR" sz="1200" b="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맑은 고딕" panose="020B0503020000020004" pitchFamily="50" charset="-127"/>
                  <a:ea typeface="맑은 고딕" panose="020B0503020000020004" pitchFamily="50" charset="-127"/>
                  <a:cs typeface="+mn-cs"/>
                </a:rPr>
                <a:t> </a:t>
              </a: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altLang="ko-KR" sz="1200" b="0" i="0" u="none" strike="noStrike" kern="1200" cap="none" spc="0" normalizeH="0" baseline="0" noProof="0">
                <a:ln>
                  <a:noFill/>
                </a:ln>
                <a:solidFill>
                  <a:srgbClr val="666666"/>
                </a:solidFill>
                <a:effectLst/>
                <a:uLnTx/>
                <a:uFillTx/>
                <a:latin typeface="맑은 고딕" panose="020B0503020000020004" pitchFamily="50" charset="-127"/>
                <a:ea typeface="맑은 고딕" panose="020B0503020000020004" pitchFamily="50" charset="-127"/>
                <a:cs typeface="+mn-cs"/>
              </a:endParaRPr>
            </a:p>
            <a:p>
              <a:r>
                <a:rPr lang="en-US" altLang="ko-KR" sz="1400" b="1"/>
                <a:t>clinical testing</a:t>
              </a:r>
            </a:p>
            <a:p>
              <a:pPr marL="0" marR="0" lvl="0" indent="0" algn="l" defTabSz="914400" rtl="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ko-KR" sz="1200" b="0" i="0" u="none" strike="noStrike" kern="1200" cap="none" spc="0" normalizeH="0" baseline="0" noProof="0">
                  <a:ln>
                    <a:noFill/>
                  </a:ln>
                  <a:solidFill>
                    <a:schemeClr val="tx1"/>
                  </a:solidFill>
                  <a:effectLst/>
                  <a:uLnTx/>
                  <a:uFillTx/>
                  <a:latin typeface="맑은 고딕" panose="020B0503020000020004" pitchFamily="50" charset="-127"/>
                  <a:ea typeface="맑은 고딕" panose="020B0503020000020004" pitchFamily="50" charset="-127"/>
                  <a:cs typeface="+mn-cs"/>
                </a:rPr>
                <a:t>• Health indicator</a:t>
              </a:r>
              <a:endParaRPr lang="ko-KR" altLang="en-US" sz="1400" b="1">
                <a:solidFill>
                  <a:schemeClr val="tx1"/>
                </a:solidFill>
              </a:endParaRPr>
            </a:p>
          </p:txBody>
        </p:sp>
        <p:sp>
          <p:nvSpPr>
            <p:cNvPr id="27" name="사각형: 둥근 모서리 26">
              <a:extLst>
                <a:ext uri="{FF2B5EF4-FFF2-40B4-BE49-F238E27FC236}">
                  <a16:creationId xmlns:a16="http://schemas.microsoft.com/office/drawing/2014/main" id="{B95632E7-1058-45E2-923B-D917C0A23829}"/>
                </a:ext>
              </a:extLst>
            </p:cNvPr>
            <p:cNvSpPr/>
            <p:nvPr/>
          </p:nvSpPr>
          <p:spPr>
            <a:xfrm>
              <a:off x="9742536" y="2416708"/>
              <a:ext cx="1705049" cy="2049784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accent4">
                <a:hueOff val="9800891"/>
                <a:satOff val="-40777"/>
                <a:lumOff val="9608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r>
                <a:rPr lang="en-US" altLang="ko-KR" sz="1400" b="1"/>
                <a:t>Biobanking of human samples </a:t>
              </a:r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• Serum, plasma, </a:t>
              </a:r>
            </a:p>
            <a:p>
              <a:r>
                <a:rPr lang="en-US" altLang="ko-KR" sz="1200">
                  <a:solidFill>
                    <a:srgbClr val="666666"/>
                  </a:solidFill>
                  <a:latin typeface="+mn-ea"/>
                </a:rPr>
                <a:t>  </a:t>
              </a:r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urine</a:t>
              </a:r>
              <a:br>
                <a:rPr lang="en-US" altLang="ko-KR" sz="1200">
                  <a:latin typeface="+mn-ea"/>
                </a:rPr>
              </a:br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• Whole blood</a:t>
              </a:r>
            </a:p>
            <a:p>
              <a:endParaRPr lang="en-US" altLang="ko-KR" sz="1200"/>
            </a:p>
            <a:p>
              <a:r>
                <a:rPr lang="en-US" altLang="ko-KR" sz="1400" b="1"/>
                <a:t>distribution</a:t>
              </a:r>
            </a:p>
            <a:p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• Future research </a:t>
              </a:r>
            </a:p>
            <a:p>
              <a:r>
                <a:rPr lang="en-US" altLang="ko-KR" sz="1200">
                  <a:solidFill>
                    <a:srgbClr val="666666"/>
                  </a:solidFill>
                  <a:latin typeface="+mn-ea"/>
                </a:rPr>
                <a:t>  </a:t>
              </a:r>
              <a:r>
                <a:rPr lang="en-US" altLang="ko-KR" sz="1200" b="0" i="0">
                  <a:solidFill>
                    <a:srgbClr val="666666"/>
                  </a:solidFill>
                  <a:effectLst/>
                  <a:latin typeface="+mn-ea"/>
                </a:rPr>
                <a:t>applications</a:t>
              </a:r>
              <a:endParaRPr lang="ko-KR" altLang="en-US" sz="1200">
                <a:latin typeface="+mn-ea"/>
              </a:endParaRPr>
            </a:p>
          </p:txBody>
        </p:sp>
        <p:sp>
          <p:nvSpPr>
            <p:cNvPr id="28" name="사각형: 둥근 모서리 27">
              <a:extLst>
                <a:ext uri="{FF2B5EF4-FFF2-40B4-BE49-F238E27FC236}">
                  <a16:creationId xmlns:a16="http://schemas.microsoft.com/office/drawing/2014/main" id="{5D5D3087-9143-456B-A739-2D074F1ED244}"/>
                </a:ext>
              </a:extLst>
            </p:cNvPr>
            <p:cNvSpPr/>
            <p:nvPr/>
          </p:nvSpPr>
          <p:spPr>
            <a:xfrm>
              <a:off x="7016262" y="1909688"/>
              <a:ext cx="668216" cy="385106"/>
            </a:xfrm>
            <a:prstGeom prst="roundRect">
              <a:avLst>
                <a:gd name="adj" fmla="val 10000"/>
              </a:avLst>
            </a:prstGeom>
            <a:solidFill>
              <a:srgbClr val="FFFF00">
                <a:alpha val="89804"/>
              </a:srgbClr>
            </a:solidFill>
            <a:ln>
              <a:solidFill>
                <a:srgbClr val="FFC000"/>
              </a:solidFill>
            </a:ln>
          </p:spPr>
          <p:style>
            <a:lnRef idx="2">
              <a:schemeClr val="accent4">
                <a:hueOff val="7350668"/>
                <a:satOff val="-30583"/>
                <a:lumOff val="7206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pPr algn="ctr"/>
              <a:r>
                <a:rPr lang="en-US" altLang="ko-KR" sz="800">
                  <a:solidFill>
                    <a:schemeClr val="tx1"/>
                  </a:solidFill>
                </a:rPr>
                <a:t>Coldchain system</a:t>
              </a:r>
              <a:endParaRPr lang="ko-KR" altLang="en-US" sz="800">
                <a:solidFill>
                  <a:schemeClr val="tx1"/>
                </a:solidFill>
              </a:endParaRPr>
            </a:p>
          </p:txBody>
        </p:sp>
        <p:sp>
          <p:nvSpPr>
            <p:cNvPr id="29" name="사각형: 둥근 모서리 28">
              <a:extLst>
                <a:ext uri="{FF2B5EF4-FFF2-40B4-BE49-F238E27FC236}">
                  <a16:creationId xmlns:a16="http://schemas.microsoft.com/office/drawing/2014/main" id="{9EA73FDF-E1EC-4BB6-ACDF-EF58515C3B7D}"/>
                </a:ext>
              </a:extLst>
            </p:cNvPr>
            <p:cNvSpPr/>
            <p:nvPr/>
          </p:nvSpPr>
          <p:spPr>
            <a:xfrm>
              <a:off x="9091246" y="1895034"/>
              <a:ext cx="671147" cy="385106"/>
            </a:xfrm>
            <a:prstGeom prst="roundRect">
              <a:avLst>
                <a:gd name="adj" fmla="val 10000"/>
              </a:avLst>
            </a:prstGeom>
            <a:solidFill>
              <a:srgbClr val="FFFF00">
                <a:alpha val="89804"/>
              </a:srgbClr>
            </a:solidFill>
            <a:ln>
              <a:solidFill>
                <a:srgbClr val="FFC000"/>
              </a:solidFill>
            </a:ln>
          </p:spPr>
          <p:style>
            <a:lnRef idx="2">
              <a:schemeClr val="accent4">
                <a:hueOff val="7350668"/>
                <a:satOff val="-30583"/>
                <a:lumOff val="7206"/>
                <a:alphaOff val="0"/>
              </a:schemeClr>
            </a:lnRef>
            <a:fillRef idx="1">
              <a:schemeClr val="lt1">
                <a:alpha val="90000"/>
                <a:hueOff val="0"/>
                <a:satOff val="0"/>
                <a:lumOff val="0"/>
                <a:alphaOff val="0"/>
              </a:schemeClr>
            </a:fillRef>
            <a:effectRef idx="0">
              <a:schemeClr val="lt1">
                <a:alpha val="90000"/>
                <a:hueOff val="0"/>
                <a:satOff val="0"/>
                <a:lumOff val="0"/>
                <a:alphaOff val="0"/>
              </a:schemeClr>
            </a:effectRef>
            <a:fontRef idx="minor">
              <a:schemeClr val="dk1">
                <a:hueOff val="0"/>
                <a:satOff val="0"/>
                <a:lumOff val="0"/>
                <a:alphaOff val="0"/>
              </a:schemeClr>
            </a:fontRef>
          </p:style>
          <p:txBody>
            <a:bodyPr/>
            <a:lstStyle/>
            <a:p>
              <a:pPr algn="ctr"/>
              <a:r>
                <a:rPr lang="en-US" altLang="ko-KR" sz="800">
                  <a:solidFill>
                    <a:schemeClr val="tx1"/>
                  </a:solidFill>
                </a:rPr>
                <a:t>Coldchain system</a:t>
              </a:r>
              <a:endParaRPr lang="ko-KR" altLang="en-US" sz="800">
                <a:solidFill>
                  <a:schemeClr val="tx1"/>
                </a:solidFill>
              </a:endParaRPr>
            </a:p>
          </p:txBody>
        </p:sp>
      </p:grpSp>
      <p:sp>
        <p:nvSpPr>
          <p:cNvPr id="3" name="사각형: 둥근 모서리 2">
            <a:extLst>
              <a:ext uri="{FF2B5EF4-FFF2-40B4-BE49-F238E27FC236}">
                <a16:creationId xmlns:a16="http://schemas.microsoft.com/office/drawing/2014/main" id="{995D42FB-AC93-81A5-83B7-1DC2509DEF3B}"/>
              </a:ext>
            </a:extLst>
          </p:cNvPr>
          <p:cNvSpPr/>
          <p:nvPr/>
        </p:nvSpPr>
        <p:spPr>
          <a:xfrm>
            <a:off x="424697" y="949233"/>
            <a:ext cx="11375417" cy="3814355"/>
          </a:xfrm>
          <a:prstGeom prst="roundRect">
            <a:avLst/>
          </a:prstGeom>
          <a:noFill/>
          <a:ln w="381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38100">
                <a:solidFill>
                  <a:schemeClr val="tx1"/>
                </a:solidFill>
              </a:ln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B0D90FE-6ED0-4E3C-A7F2-139B2B568309}"/>
              </a:ext>
            </a:extLst>
          </p:cNvPr>
          <p:cNvSpPr txBox="1"/>
          <p:nvPr/>
        </p:nvSpPr>
        <p:spPr>
          <a:xfrm>
            <a:off x="712177" y="4862146"/>
            <a:ext cx="10568354" cy="3342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굴림" panose="020B0600000101010101" pitchFamily="50" charset="-127"/>
                <a:cs typeface="굴림" panose="020B0600000101010101" pitchFamily="50" charset="-127"/>
              </a:rPr>
              <a:t>Supplementary Material 1. KoHESS operational framework: From field collection to data management</a:t>
            </a:r>
            <a:endParaRPr lang="ko-KR" altLang="ko-KR" sz="200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  <p:graphicFrame>
        <p:nvGraphicFramePr>
          <p:cNvPr id="20" name="내용 개체 틀 4">
            <a:extLst>
              <a:ext uri="{FF2B5EF4-FFF2-40B4-BE49-F238E27FC236}">
                <a16:creationId xmlns:a16="http://schemas.microsoft.com/office/drawing/2014/main" id="{078FE2FC-82F2-4098-BB5B-7040D41F130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8378475"/>
              </p:ext>
            </p:extLst>
          </p:nvPr>
        </p:nvGraphicFramePr>
        <p:xfrm>
          <a:off x="746998" y="218765"/>
          <a:ext cx="10746037" cy="284095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sp>
        <p:nvSpPr>
          <p:cNvPr id="30" name="사각형: 둥근 모서리 29">
            <a:extLst>
              <a:ext uri="{FF2B5EF4-FFF2-40B4-BE49-F238E27FC236}">
                <a16:creationId xmlns:a16="http://schemas.microsoft.com/office/drawing/2014/main" id="{DAD40BE6-890E-4DCD-AFA0-AFDF6F445AEC}"/>
              </a:ext>
            </a:extLst>
          </p:cNvPr>
          <p:cNvSpPr/>
          <p:nvPr/>
        </p:nvSpPr>
        <p:spPr>
          <a:xfrm>
            <a:off x="433489" y="922856"/>
            <a:ext cx="11375417" cy="3814355"/>
          </a:xfrm>
          <a:prstGeom prst="roundRect">
            <a:avLst/>
          </a:prstGeom>
          <a:noFill/>
          <a:ln w="38100"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n w="38100">
                <a:solidFill>
                  <a:schemeClr val="tx1"/>
                </a:solidFill>
              </a:ln>
            </a:endParaRPr>
          </a:p>
        </p:txBody>
      </p:sp>
    </p:spTree>
    <p:extLst>
      <p:ext uri="{BB962C8B-B14F-4D97-AF65-F5344CB8AC3E}">
        <p14:creationId xmlns:p14="http://schemas.microsoft.com/office/powerpoint/2010/main" val="8246395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</TotalTime>
  <Words>146</Words>
  <Application>Microsoft Office PowerPoint</Application>
  <PresentationFormat>와이드스크린</PresentationFormat>
  <Paragraphs>44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굴림</vt:lpstr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보리</dc:creator>
  <cp:lastModifiedBy>김보리</cp:lastModifiedBy>
  <cp:revision>26</cp:revision>
  <dcterms:created xsi:type="dcterms:W3CDTF">2025-09-29T01:50:07Z</dcterms:created>
  <dcterms:modified xsi:type="dcterms:W3CDTF">2025-12-09T04:30:01Z</dcterms:modified>
</cp:coreProperties>
</file>